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596" autoAdjust="0"/>
    <p:restoredTop sz="94530" autoAdjust="0"/>
  </p:normalViewPr>
  <p:slideViewPr>
    <p:cSldViewPr>
      <p:cViewPr>
        <p:scale>
          <a:sx n="60" d="100"/>
          <a:sy n="60" d="100"/>
        </p:scale>
        <p:origin x="-1734" y="-28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cmr000117\jk891\WP\papers\CORONARY_FLOW_SKYRA\DATA%20FOR%20SCMR%20AND%20ISMRM%20ABSTRACTS%202015\JK\Automatic\PremdeepNIROULA\right\PN%20RCA%20restFINAL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\\cmr000117\jk891\WP\papers\CORONARY_FLOW_SKYRA\DATA%20FOR%20SCMR%20AND%20ISMRM%20ABSTRACTS%202015\JK\Automatic\MaureenTHORLEY\MT_LAD_FINAL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\\cmr000117\jk891\WP\papers\CORONARY_FLOW_SKYRA\DATA%20FOR%20SCMR%20AND%20ISMRM%20ABSTRACTS%202015\JK\Automatic\MartinDooley\lad\MD_LEFT_Combined_FINAL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\\cmr000117\jk891\WP\papers\CORONARY_FLOW_SKYRA\DATA%20FOR%20SCMR%20AND%20ISMRM%20ABSTRACTS%202015\JK\Automatic\KetanCHANDARANA\left\KC%20LAD%20INV_FINAL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cmr000117\jk891\WP\papers\CORONARY_FLOW_SKYRA\DATA%20FOR%20SCMR%20AND%20ISMRM%20ABSTRACTS%202015\JK\Automatic\LeahMINET\right\COMBINED_LM_RCA_FINAL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cmr000117\jk891\WP\papers\CORONARY_FLOW_SKYRA\DATA%20FOR%20SCMR%20AND%20ISMRM%20ABSTRACTS%202015\JK\Automatic\Basti_Magar_Pun\right\BPM_COMBINED_RCA_FINAL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cmr000117\jk891\WP\papers\CORONARY_FLOW_SKYRA\DATA%20FOR%20SCMR%20AND%20ISMRM%20ABSTRACTS%202015\JK\Automatic\MartinDooley\rca\COMBINED_MD_RCA_FINAL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cmr000117\jk891\WP\papers\CORONARY_FLOW_SKYRA\DATA%20FOR%20SCMR%20AND%20ISMRM%20ABSTRACTS%202015\JK\Automatic\StephenREILLY\left\SR_LEFT_FINAL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cmr000117\jk891\WP\papers\CORONARY_FLOW_SKYRA\DATA%20FOR%20SCMR%20AND%20ISMRM%20ABSTRACTS%202015\JK\Automatic\KennethIRVINE\left\COMBINED_KI_LAD_FINAL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\\cmr000117\jk891\WP\papers\CORONARY_FLOW_SKYRA\DATA%20FOR%20SCMR%20AND%20ISMRM%20ABSTRACTS%202015\JK\Automatic\PremdeepNIROULA\left\niroula_FINAL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\\cmr000117\jk891\WP\papers\CORONARY_FLOW_SKYRA\DATA%20FOR%20SCMR%20AND%20ISMRM%20ABSTRACTS%202015\JK\Automatic\LeahMINET\left\COMBINED_LM_LAD_FINAL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\\cmr000117\jk891\WP\papers\CORONARY_FLOW_SKYRA\DATA%20FOR%20SCMR%20AND%20ISMRM%20ABSTRACTS%202015\JK\Automatic\Basti_Magar_Pun\left\BPM_LEFT_combined_REPEAT%20TO%20DEAL%20WITH%20NEGATIVE%20FLOW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3"/>
            <c:spPr>
              <a:noFill/>
              <a:ln>
                <a:solidFill>
                  <a:schemeClr val="tx1"/>
                </a:solidFill>
              </a:ln>
            </c:spPr>
          </c:marker>
          <c:trendline>
            <c:spPr>
              <a:ln>
                <a:solidFill>
                  <a:schemeClr val="tx1"/>
                </a:solidFill>
              </a:ln>
            </c:spPr>
            <c:trendlineType val="linear"/>
            <c:dispRSqr val="1"/>
            <c:dispEq val="1"/>
            <c:trendlineLbl>
              <c:layout>
                <c:manualLayout>
                  <c:x val="0.38851078439292352"/>
                  <c:y val="0.21335959297554571"/>
                </c:manualLayout>
              </c:layout>
              <c:tx>
                <c:rich>
                  <a:bodyPr/>
                  <a:lstStyle/>
                  <a:p>
                    <a:pPr>
                      <a:defRPr sz="1200">
                        <a:solidFill>
                          <a:schemeClr val="tx1"/>
                        </a:solidFill>
                      </a:defRPr>
                    </a:pPr>
                    <a:r>
                      <a:rPr lang="en-US" baseline="0" dirty="0" smtClean="0"/>
                      <a:t>Patient 7 </a:t>
                    </a:r>
                  </a:p>
                  <a:p>
                    <a:pPr>
                      <a:defRPr sz="1200">
                        <a:solidFill>
                          <a:schemeClr val="tx1"/>
                        </a:solidFill>
                      </a:defRPr>
                    </a:pPr>
                    <a:r>
                      <a:rPr lang="en-US" baseline="0" dirty="0" smtClean="0"/>
                      <a:t>r </a:t>
                    </a:r>
                    <a:r>
                      <a:rPr lang="en-US" baseline="0" dirty="0"/>
                      <a:t>= </a:t>
                    </a:r>
                    <a:r>
                      <a:rPr lang="en-US" baseline="0" dirty="0" smtClean="0"/>
                      <a:t>0.93</a:t>
                    </a:r>
                    <a:endParaRPr lang="en-US" dirty="0"/>
                  </a:p>
                </c:rich>
              </c:tx>
              <c:numFmt formatCode="General" sourceLinked="0"/>
            </c:trendlineLbl>
          </c:trendline>
          <c:xVal>
            <c:numRef>
              <c:f>Sheet2!$V$32:$V$194</c:f>
              <c:numCache>
                <c:formatCode>General</c:formatCode>
                <c:ptCount val="163"/>
                <c:pt idx="2">
                  <c:v>55.663454545454542</c:v>
                </c:pt>
                <c:pt idx="3">
                  <c:v>56.749272727272718</c:v>
                </c:pt>
                <c:pt idx="4">
                  <c:v>59.30181818181817</c:v>
                </c:pt>
                <c:pt idx="5">
                  <c:v>63.64618181818183</c:v>
                </c:pt>
                <c:pt idx="6">
                  <c:v>69.728545454545454</c:v>
                </c:pt>
                <c:pt idx="7">
                  <c:v>77.168727272727267</c:v>
                </c:pt>
                <c:pt idx="8">
                  <c:v>85.423454545454533</c:v>
                </c:pt>
                <c:pt idx="9">
                  <c:v>93.406909090909124</c:v>
                </c:pt>
                <c:pt idx="10">
                  <c:v>100.304</c:v>
                </c:pt>
                <c:pt idx="11">
                  <c:v>105.68036363636364</c:v>
                </c:pt>
                <c:pt idx="12">
                  <c:v>109.6989090909091</c:v>
                </c:pt>
                <c:pt idx="13">
                  <c:v>113.44600000000001</c:v>
                </c:pt>
                <c:pt idx="14">
                  <c:v>117.19272727272724</c:v>
                </c:pt>
                <c:pt idx="15">
                  <c:v>120.88563636363637</c:v>
                </c:pt>
                <c:pt idx="16">
                  <c:v>124.36072727272725</c:v>
                </c:pt>
                <c:pt idx="17">
                  <c:v>126.85872727272724</c:v>
                </c:pt>
                <c:pt idx="18">
                  <c:v>127.56454545454545</c:v>
                </c:pt>
                <c:pt idx="19">
                  <c:v>127.02145454545455</c:v>
                </c:pt>
                <c:pt idx="20">
                  <c:v>125.98945454545455</c:v>
                </c:pt>
                <c:pt idx="21">
                  <c:v>124.8490909090909</c:v>
                </c:pt>
                <c:pt idx="22">
                  <c:v>123.49145454545456</c:v>
                </c:pt>
                <c:pt idx="23">
                  <c:v>122.29709090909093</c:v>
                </c:pt>
                <c:pt idx="24">
                  <c:v>120.45072727272728</c:v>
                </c:pt>
                <c:pt idx="25">
                  <c:v>117.19272727272724</c:v>
                </c:pt>
                <c:pt idx="26">
                  <c:v>113.28290909090909</c:v>
                </c:pt>
                <c:pt idx="27">
                  <c:v>109.10163636363635</c:v>
                </c:pt>
                <c:pt idx="28">
                  <c:v>104.37690909090908</c:v>
                </c:pt>
                <c:pt idx="29">
                  <c:v>99.978363636363611</c:v>
                </c:pt>
                <c:pt idx="30">
                  <c:v>96.068000000000012</c:v>
                </c:pt>
                <c:pt idx="31">
                  <c:v>92.157636363636342</c:v>
                </c:pt>
                <c:pt idx="32">
                  <c:v>88.518909090909091</c:v>
                </c:pt>
                <c:pt idx="33">
                  <c:v>85.206181818181804</c:v>
                </c:pt>
                <c:pt idx="34">
                  <c:v>81.838909090909084</c:v>
                </c:pt>
                <c:pt idx="35">
                  <c:v>78.309454545454543</c:v>
                </c:pt>
                <c:pt idx="41">
                  <c:v>-79.232727272727288</c:v>
                </c:pt>
                <c:pt idx="42">
                  <c:v>-84.229272727272701</c:v>
                </c:pt>
                <c:pt idx="43">
                  <c:v>-89.551090909090902</c:v>
                </c:pt>
                <c:pt idx="44">
                  <c:v>-94.167090909090902</c:v>
                </c:pt>
                <c:pt idx="45">
                  <c:v>-97.588545454545482</c:v>
                </c:pt>
                <c:pt idx="46">
                  <c:v>-99.706181818181776</c:v>
                </c:pt>
                <c:pt idx="47">
                  <c:v>-100.95490909090901</c:v>
                </c:pt>
                <c:pt idx="48">
                  <c:v>-101.76945454545502</c:v>
                </c:pt>
                <c:pt idx="49">
                  <c:v>-102.693090909091</c:v>
                </c:pt>
                <c:pt idx="50">
                  <c:v>-103.779090909091</c:v>
                </c:pt>
                <c:pt idx="51">
                  <c:v>-105.24581818181801</c:v>
                </c:pt>
                <c:pt idx="52">
                  <c:v>-106.71218181818199</c:v>
                </c:pt>
                <c:pt idx="53">
                  <c:v>-107.14690909090902</c:v>
                </c:pt>
                <c:pt idx="54">
                  <c:v>-107.09181818181801</c:v>
                </c:pt>
                <c:pt idx="55">
                  <c:v>-106.331454545455</c:v>
                </c:pt>
                <c:pt idx="56">
                  <c:v>-103.453272727273</c:v>
                </c:pt>
                <c:pt idx="57">
                  <c:v>-98.837090909090904</c:v>
                </c:pt>
                <c:pt idx="58">
                  <c:v>-93.623454545454479</c:v>
                </c:pt>
                <c:pt idx="59">
                  <c:v>-87.704545454545496</c:v>
                </c:pt>
                <c:pt idx="60">
                  <c:v>-81.730727272727279</c:v>
                </c:pt>
                <c:pt idx="61">
                  <c:v>-76.897272727272707</c:v>
                </c:pt>
                <c:pt idx="62">
                  <c:v>-72.8243636363636</c:v>
                </c:pt>
                <c:pt idx="63">
                  <c:v>-69.240363636363597</c:v>
                </c:pt>
                <c:pt idx="64">
                  <c:v>-65.601818181818203</c:v>
                </c:pt>
                <c:pt idx="65">
                  <c:v>-61.963454545454596</c:v>
                </c:pt>
                <c:pt idx="71">
                  <c:v>73.856909090909085</c:v>
                </c:pt>
                <c:pt idx="72">
                  <c:v>80.753999999999991</c:v>
                </c:pt>
                <c:pt idx="73">
                  <c:v>87.48745454545454</c:v>
                </c:pt>
                <c:pt idx="74">
                  <c:v>93.895818181818171</c:v>
                </c:pt>
                <c:pt idx="75">
                  <c:v>100.46690909090908</c:v>
                </c:pt>
                <c:pt idx="76">
                  <c:v>106.76618181818179</c:v>
                </c:pt>
                <c:pt idx="77">
                  <c:v>113.06563636363633</c:v>
                </c:pt>
                <c:pt idx="78">
                  <c:v>119.36527272727271</c:v>
                </c:pt>
                <c:pt idx="79">
                  <c:v>125.33836363636361</c:v>
                </c:pt>
                <c:pt idx="80">
                  <c:v>131.47490909090908</c:v>
                </c:pt>
                <c:pt idx="81">
                  <c:v>138.15454545454543</c:v>
                </c:pt>
                <c:pt idx="82">
                  <c:v>144.88836363636364</c:v>
                </c:pt>
                <c:pt idx="83">
                  <c:v>151.89418181818183</c:v>
                </c:pt>
                <c:pt idx="84">
                  <c:v>159.38890909090915</c:v>
                </c:pt>
                <c:pt idx="85">
                  <c:v>166.44872727272727</c:v>
                </c:pt>
                <c:pt idx="86">
                  <c:v>172.58527272727272</c:v>
                </c:pt>
                <c:pt idx="87">
                  <c:v>177.96163636363644</c:v>
                </c:pt>
                <c:pt idx="88">
                  <c:v>182.14327272727269</c:v>
                </c:pt>
                <c:pt idx="89">
                  <c:v>185.1843636363636</c:v>
                </c:pt>
                <c:pt idx="90">
                  <c:v>187.46509090909095</c:v>
                </c:pt>
                <c:pt idx="91">
                  <c:v>189.14872727272729</c:v>
                </c:pt>
                <c:pt idx="92">
                  <c:v>190.07218181818183</c:v>
                </c:pt>
                <c:pt idx="93">
                  <c:v>190.34363636363639</c:v>
                </c:pt>
                <c:pt idx="94">
                  <c:v>189.63781818181818</c:v>
                </c:pt>
                <c:pt idx="95">
                  <c:v>188.172</c:v>
                </c:pt>
                <c:pt idx="96">
                  <c:v>185.99963636363643</c:v>
                </c:pt>
                <c:pt idx="97">
                  <c:v>183.44690909090909</c:v>
                </c:pt>
                <c:pt idx="98">
                  <c:v>181.22</c:v>
                </c:pt>
                <c:pt idx="99">
                  <c:v>179.48181818181817</c:v>
                </c:pt>
                <c:pt idx="100">
                  <c:v>177.63509090909093</c:v>
                </c:pt>
                <c:pt idx="101">
                  <c:v>175.626</c:v>
                </c:pt>
                <c:pt idx="102">
                  <c:v>173.23654545454545</c:v>
                </c:pt>
                <c:pt idx="103">
                  <c:v>169.92381818181818</c:v>
                </c:pt>
                <c:pt idx="104">
                  <c:v>166.01363636363641</c:v>
                </c:pt>
                <c:pt idx="105">
                  <c:v>161.88636363636365</c:v>
                </c:pt>
                <c:pt idx="106">
                  <c:v>157.75909090909093</c:v>
                </c:pt>
                <c:pt idx="107">
                  <c:v>153.68636363636364</c:v>
                </c:pt>
                <c:pt idx="108">
                  <c:v>149.66781818181818</c:v>
                </c:pt>
                <c:pt idx="109">
                  <c:v>145.70363636363638</c:v>
                </c:pt>
                <c:pt idx="110">
                  <c:v>141.52181818181819</c:v>
                </c:pt>
                <c:pt idx="111">
                  <c:v>137.2856363636364</c:v>
                </c:pt>
                <c:pt idx="112">
                  <c:v>133.32127272727271</c:v>
                </c:pt>
                <c:pt idx="113">
                  <c:v>129.57418181818178</c:v>
                </c:pt>
                <c:pt idx="114">
                  <c:v>126.26145454545454</c:v>
                </c:pt>
                <c:pt idx="115">
                  <c:v>123.54636363636365</c:v>
                </c:pt>
                <c:pt idx="116">
                  <c:v>120.88545454545454</c:v>
                </c:pt>
                <c:pt idx="117">
                  <c:v>118.22454545454546</c:v>
                </c:pt>
                <c:pt idx="118">
                  <c:v>115.78054545454549</c:v>
                </c:pt>
                <c:pt idx="119">
                  <c:v>113.11963636363636</c:v>
                </c:pt>
                <c:pt idx="120">
                  <c:v>110.62163636363636</c:v>
                </c:pt>
                <c:pt idx="121">
                  <c:v>108.44945454545454</c:v>
                </c:pt>
                <c:pt idx="122">
                  <c:v>106.54854545454546</c:v>
                </c:pt>
                <c:pt idx="123">
                  <c:v>105.02854545454545</c:v>
                </c:pt>
                <c:pt idx="124">
                  <c:v>103.94236363636365</c:v>
                </c:pt>
                <c:pt idx="125">
                  <c:v>103.07363636363635</c:v>
                </c:pt>
                <c:pt idx="126">
                  <c:v>102.53072727272728</c:v>
                </c:pt>
                <c:pt idx="127">
                  <c:v>102.25927272727273</c:v>
                </c:pt>
                <c:pt idx="128">
                  <c:v>102.09618181818179</c:v>
                </c:pt>
                <c:pt idx="129">
                  <c:v>101.98763636363637</c:v>
                </c:pt>
                <c:pt idx="130">
                  <c:v>101.87890909090909</c:v>
                </c:pt>
                <c:pt idx="131">
                  <c:v>101.98763636363637</c:v>
                </c:pt>
                <c:pt idx="132">
                  <c:v>102.4218181818182</c:v>
                </c:pt>
                <c:pt idx="133">
                  <c:v>103.29072727272728</c:v>
                </c:pt>
                <c:pt idx="134">
                  <c:v>104.70309090909093</c:v>
                </c:pt>
                <c:pt idx="135">
                  <c:v>106.38672727272727</c:v>
                </c:pt>
                <c:pt idx="136">
                  <c:v>107.96163636363637</c:v>
                </c:pt>
                <c:pt idx="137">
                  <c:v>109.37400000000001</c:v>
                </c:pt>
                <c:pt idx="138">
                  <c:v>110.46036363636367</c:v>
                </c:pt>
                <c:pt idx="139">
                  <c:v>110.89454545454548</c:v>
                </c:pt>
                <c:pt idx="140">
                  <c:v>110.94909090909093</c:v>
                </c:pt>
                <c:pt idx="141">
                  <c:v>110.62290909090908</c:v>
                </c:pt>
                <c:pt idx="142">
                  <c:v>109.37381818181818</c:v>
                </c:pt>
                <c:pt idx="143">
                  <c:v>107.96163636363637</c:v>
                </c:pt>
                <c:pt idx="144">
                  <c:v>106.49563636363635</c:v>
                </c:pt>
                <c:pt idx="145">
                  <c:v>104.43145454545456</c:v>
                </c:pt>
                <c:pt idx="146">
                  <c:v>101.87909090909092</c:v>
                </c:pt>
                <c:pt idx="147">
                  <c:v>99.10945454545454</c:v>
                </c:pt>
                <c:pt idx="148">
                  <c:v>95.416181818181798</c:v>
                </c:pt>
                <c:pt idx="149">
                  <c:v>91.342545454545473</c:v>
                </c:pt>
                <c:pt idx="150">
                  <c:v>87.921090909090907</c:v>
                </c:pt>
                <c:pt idx="151">
                  <c:v>85.205818181818174</c:v>
                </c:pt>
                <c:pt idx="152">
                  <c:v>83.304909090909092</c:v>
                </c:pt>
                <c:pt idx="153">
                  <c:v>82.056363636363642</c:v>
                </c:pt>
                <c:pt idx="154">
                  <c:v>81.187636363636358</c:v>
                </c:pt>
                <c:pt idx="155">
                  <c:v>80.210181818181809</c:v>
                </c:pt>
                <c:pt idx="156">
                  <c:v>78.961272727272743</c:v>
                </c:pt>
                <c:pt idx="157">
                  <c:v>77.494909090909104</c:v>
                </c:pt>
                <c:pt idx="158">
                  <c:v>76.082727272727269</c:v>
                </c:pt>
                <c:pt idx="159">
                  <c:v>74.790000000000006</c:v>
                </c:pt>
                <c:pt idx="160">
                  <c:v>73.481363636363653</c:v>
                </c:pt>
                <c:pt idx="161">
                  <c:v>72.2595818181818</c:v>
                </c:pt>
                <c:pt idx="162">
                  <c:v>71.059563636363663</c:v>
                </c:pt>
              </c:numCache>
            </c:numRef>
          </c:xVal>
          <c:yVal>
            <c:numRef>
              <c:f>Sheet2!$U$32:$U$194</c:f>
              <c:numCache>
                <c:formatCode>General</c:formatCode>
                <c:ptCount val="163"/>
                <c:pt idx="0">
                  <c:v>39.520795751912296</c:v>
                </c:pt>
                <c:pt idx="3">
                  <c:v>53.094079698357476</c:v>
                </c:pt>
                <c:pt idx="7">
                  <c:v>43.412736929042943</c:v>
                </c:pt>
                <c:pt idx="10">
                  <c:v>30.702659197763406</c:v>
                </c:pt>
                <c:pt idx="13">
                  <c:v>33.387852483950418</c:v>
                </c:pt>
                <c:pt idx="16">
                  <c:v>21.467672429412104</c:v>
                </c:pt>
                <c:pt idx="19">
                  <c:v>78.645216684161696</c:v>
                </c:pt>
                <c:pt idx="22">
                  <c:v>94.980478316326511</c:v>
                </c:pt>
                <c:pt idx="25">
                  <c:v>73.065619261164571</c:v>
                </c:pt>
                <c:pt idx="28">
                  <c:v>51.624295812074848</c:v>
                </c:pt>
                <c:pt idx="31">
                  <c:v>40.406522326083739</c:v>
                </c:pt>
                <c:pt idx="35">
                  <c:v>18.99621015589371</c:v>
                </c:pt>
                <c:pt idx="41">
                  <c:v>-26.391365551154674</c:v>
                </c:pt>
                <c:pt idx="44">
                  <c:v>-54.39688496748186</c:v>
                </c:pt>
                <c:pt idx="47">
                  <c:v>-66.508687086823997</c:v>
                </c:pt>
                <c:pt idx="50">
                  <c:v>-67.079842246431753</c:v>
                </c:pt>
                <c:pt idx="53">
                  <c:v>-67.030504318650287</c:v>
                </c:pt>
                <c:pt idx="56">
                  <c:v>-53.919016781626922</c:v>
                </c:pt>
                <c:pt idx="59">
                  <c:v>-42.78646254735569</c:v>
                </c:pt>
                <c:pt idx="62">
                  <c:v>-36.013213927074503</c:v>
                </c:pt>
                <c:pt idx="65">
                  <c:v>-21.19292689491153</c:v>
                </c:pt>
                <c:pt idx="71">
                  <c:v>47.949207553456759</c:v>
                </c:pt>
                <c:pt idx="75">
                  <c:v>66.138765150730308</c:v>
                </c:pt>
                <c:pt idx="78">
                  <c:v>86.315603963483412</c:v>
                </c:pt>
                <c:pt idx="81">
                  <c:v>111.13171922602224</c:v>
                </c:pt>
                <c:pt idx="84">
                  <c:v>126.02521526130518</c:v>
                </c:pt>
                <c:pt idx="87">
                  <c:v>141.53213487537437</c:v>
                </c:pt>
                <c:pt idx="90">
                  <c:v>155.89968545788705</c:v>
                </c:pt>
                <c:pt idx="93">
                  <c:v>154.64371113163526</c:v>
                </c:pt>
                <c:pt idx="96">
                  <c:v>143.69968695736341</c:v>
                </c:pt>
                <c:pt idx="99">
                  <c:v>140.98369738520415</c:v>
                </c:pt>
                <c:pt idx="102">
                  <c:v>140.24094700823144</c:v>
                </c:pt>
                <c:pt idx="105">
                  <c:v>138.74573793066088</c:v>
                </c:pt>
                <c:pt idx="108">
                  <c:v>129.29195371446667</c:v>
                </c:pt>
                <c:pt idx="111">
                  <c:v>123.35521293812901</c:v>
                </c:pt>
                <c:pt idx="114">
                  <c:v>118.06717532708105</c:v>
                </c:pt>
                <c:pt idx="118">
                  <c:v>113.18388880080661</c:v>
                </c:pt>
                <c:pt idx="121">
                  <c:v>111.13546209938981</c:v>
                </c:pt>
                <c:pt idx="124">
                  <c:v>106.4198082578384</c:v>
                </c:pt>
                <c:pt idx="127">
                  <c:v>117.2576935965064</c:v>
                </c:pt>
                <c:pt idx="130">
                  <c:v>123.82309618978404</c:v>
                </c:pt>
                <c:pt idx="133">
                  <c:v>120.48347710794845</c:v>
                </c:pt>
                <c:pt idx="136">
                  <c:v>100.60022160480912</c:v>
                </c:pt>
                <c:pt idx="139">
                  <c:v>86.4719951593177</c:v>
                </c:pt>
                <c:pt idx="142">
                  <c:v>92.18692593375664</c:v>
                </c:pt>
                <c:pt idx="145">
                  <c:v>90.516801909908693</c:v>
                </c:pt>
                <c:pt idx="148">
                  <c:v>60.45684840331561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2403328"/>
        <c:axId val="192404864"/>
      </c:scatterChart>
      <c:valAx>
        <c:axId val="192403328"/>
        <c:scaling>
          <c:orientation val="minMax"/>
          <c:max val="400"/>
          <c:min val="-20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solidFill>
                  <a:schemeClr val="tx1"/>
                </a:solidFill>
              </a:defRPr>
            </a:pPr>
            <a:endParaRPr lang="en-US"/>
          </a:p>
        </c:txPr>
        <c:crossAx val="192404864"/>
        <c:crosses val="autoZero"/>
        <c:crossBetween val="midCat"/>
        <c:majorUnit val="200"/>
      </c:valAx>
      <c:valAx>
        <c:axId val="192404864"/>
        <c:scaling>
          <c:orientation val="minMax"/>
          <c:max val="200"/>
          <c:min val="-10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solidFill>
                  <a:schemeClr val="tx1"/>
                </a:solidFill>
              </a:defRPr>
            </a:pPr>
            <a:endParaRPr lang="en-US"/>
          </a:p>
        </c:txPr>
        <c:crossAx val="192403328"/>
        <c:crosses val="autoZero"/>
        <c:crossBetween val="midCat"/>
        <c:majorUnit val="100"/>
      </c:valAx>
    </c:plotArea>
    <c:plotVisOnly val="1"/>
    <c:dispBlanksAs val="gap"/>
    <c:showDLblsOverMax val="0"/>
  </c:chart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3"/>
            <c:spPr>
              <a:noFill/>
              <a:ln>
                <a:solidFill>
                  <a:schemeClr val="tx1"/>
                </a:solidFill>
              </a:ln>
            </c:spPr>
          </c:marker>
          <c:trendline>
            <c:spPr>
              <a:ln>
                <a:solidFill>
                  <a:schemeClr val="tx1"/>
                </a:solidFill>
              </a:ln>
            </c:spPr>
            <c:trendlineType val="linear"/>
            <c:dispRSqr val="1"/>
            <c:dispEq val="1"/>
            <c:trendlineLbl>
              <c:layout>
                <c:manualLayout>
                  <c:x val="-0.22782286614173228"/>
                  <c:y val="-9.0579722310830543E-2"/>
                </c:manualLayout>
              </c:layout>
              <c:tx>
                <c:rich>
                  <a:bodyPr/>
                  <a:lstStyle/>
                  <a:p>
                    <a:pPr>
                      <a:defRPr sz="1200">
                        <a:solidFill>
                          <a:schemeClr val="tx1"/>
                        </a:solidFill>
                      </a:defRPr>
                    </a:pPr>
                    <a:r>
                      <a:rPr lang="en-US" baseline="0" dirty="0" smtClean="0"/>
                      <a:t>Patient 1 </a:t>
                    </a:r>
                  </a:p>
                  <a:p>
                    <a:pPr>
                      <a:defRPr sz="1200">
                        <a:solidFill>
                          <a:schemeClr val="tx1"/>
                        </a:solidFill>
                      </a:defRPr>
                    </a:pPr>
                    <a:r>
                      <a:rPr lang="en-US" baseline="0" dirty="0" smtClean="0"/>
                      <a:t>r </a:t>
                    </a:r>
                    <a:r>
                      <a:rPr lang="en-US" baseline="0" dirty="0"/>
                      <a:t>= </a:t>
                    </a:r>
                    <a:r>
                      <a:rPr lang="en-US" baseline="0" dirty="0" smtClean="0"/>
                      <a:t>0.96</a:t>
                    </a:r>
                    <a:endParaRPr lang="en-US" baseline="0" dirty="0"/>
                  </a:p>
                </c:rich>
              </c:tx>
              <c:numFmt formatCode="General" sourceLinked="0"/>
            </c:trendlineLbl>
          </c:trendline>
          <c:xVal>
            <c:numRef>
              <c:f>Sheet2!$B$20:$B$180</c:f>
              <c:numCache>
                <c:formatCode>General</c:formatCode>
                <c:ptCount val="161"/>
                <c:pt idx="2">
                  <c:v>354.9782222222222</c:v>
                </c:pt>
                <c:pt idx="3">
                  <c:v>362.0137777777777</c:v>
                </c:pt>
                <c:pt idx="4">
                  <c:v>365.46511111111101</c:v>
                </c:pt>
                <c:pt idx="5">
                  <c:v>363.34088888888897</c:v>
                </c:pt>
                <c:pt idx="6">
                  <c:v>353.78266666666673</c:v>
                </c:pt>
                <c:pt idx="7">
                  <c:v>335.86066666666676</c:v>
                </c:pt>
                <c:pt idx="8">
                  <c:v>311.43444444444441</c:v>
                </c:pt>
                <c:pt idx="9">
                  <c:v>284.35333333333341</c:v>
                </c:pt>
                <c:pt idx="16">
                  <c:v>-203.37577777777798</c:v>
                </c:pt>
                <c:pt idx="17">
                  <c:v>-191.56066666666698</c:v>
                </c:pt>
                <c:pt idx="18">
                  <c:v>-178.01977777777796</c:v>
                </c:pt>
                <c:pt idx="19">
                  <c:v>-163.41711111111098</c:v>
                </c:pt>
                <c:pt idx="20">
                  <c:v>-150.14222222222199</c:v>
                </c:pt>
                <c:pt idx="21">
                  <c:v>-139.25666666666697</c:v>
                </c:pt>
                <c:pt idx="22">
                  <c:v>-131.026222222222</c:v>
                </c:pt>
                <c:pt idx="23">
                  <c:v>-126.24711111111101</c:v>
                </c:pt>
                <c:pt idx="24">
                  <c:v>-124.388222222222</c:v>
                </c:pt>
                <c:pt idx="25">
                  <c:v>-123.724</c:v>
                </c:pt>
                <c:pt idx="26">
                  <c:v>-123.32555555555597</c:v>
                </c:pt>
                <c:pt idx="27">
                  <c:v>-121.99822222222201</c:v>
                </c:pt>
                <c:pt idx="28">
                  <c:v>-118.54711111111099</c:v>
                </c:pt>
                <c:pt idx="29">
                  <c:v>-113.23666666666703</c:v>
                </c:pt>
                <c:pt idx="30">
                  <c:v>-105.93555555555598</c:v>
                </c:pt>
                <c:pt idx="31">
                  <c:v>-97.439555555555501</c:v>
                </c:pt>
                <c:pt idx="32">
                  <c:v>-88.810666666666705</c:v>
                </c:pt>
                <c:pt idx="33">
                  <c:v>-79.916222222222217</c:v>
                </c:pt>
                <c:pt idx="34">
                  <c:v>-71.685999999999993</c:v>
                </c:pt>
                <c:pt idx="35">
                  <c:v>-64.915999999999997</c:v>
                </c:pt>
                <c:pt idx="36">
                  <c:v>-59.473111111111102</c:v>
                </c:pt>
                <c:pt idx="37">
                  <c:v>-55.623111111111108</c:v>
                </c:pt>
                <c:pt idx="50">
                  <c:v>80.581111111111113</c:v>
                </c:pt>
                <c:pt idx="51">
                  <c:v>82.307111111111112</c:v>
                </c:pt>
                <c:pt idx="52">
                  <c:v>83.634444444444455</c:v>
                </c:pt>
                <c:pt idx="53">
                  <c:v>84.298444444444456</c:v>
                </c:pt>
                <c:pt idx="54">
                  <c:v>84.431555555555562</c:v>
                </c:pt>
                <c:pt idx="55">
                  <c:v>85.493777777777751</c:v>
                </c:pt>
                <c:pt idx="56">
                  <c:v>85.626444444444431</c:v>
                </c:pt>
                <c:pt idx="57">
                  <c:v>84.166222222222217</c:v>
                </c:pt>
                <c:pt idx="58">
                  <c:v>81.776666666666671</c:v>
                </c:pt>
                <c:pt idx="59">
                  <c:v>78.457555555555572</c:v>
                </c:pt>
                <c:pt idx="60">
                  <c:v>74.474444444444472</c:v>
                </c:pt>
                <c:pt idx="61">
                  <c:v>71.421111111111117</c:v>
                </c:pt>
                <c:pt idx="62">
                  <c:v>70.359111111111119</c:v>
                </c:pt>
                <c:pt idx="77">
                  <c:v>268.2908888888889</c:v>
                </c:pt>
                <c:pt idx="78">
                  <c:v>300.94799999999992</c:v>
                </c:pt>
                <c:pt idx="79">
                  <c:v>335.7286666666667</c:v>
                </c:pt>
                <c:pt idx="80">
                  <c:v>374.62466666666677</c:v>
                </c:pt>
                <c:pt idx="81">
                  <c:v>419.09644444444444</c:v>
                </c:pt>
                <c:pt idx="82">
                  <c:v>464.76288888888899</c:v>
                </c:pt>
                <c:pt idx="83">
                  <c:v>513.34977777777783</c:v>
                </c:pt>
                <c:pt idx="84">
                  <c:v>563.26444444444439</c:v>
                </c:pt>
                <c:pt idx="85">
                  <c:v>610.65688888888872</c:v>
                </c:pt>
                <c:pt idx="86">
                  <c:v>653.403111111111</c:v>
                </c:pt>
                <c:pt idx="87">
                  <c:v>690.57355555555569</c:v>
                </c:pt>
                <c:pt idx="88">
                  <c:v>719.24755555555544</c:v>
                </c:pt>
                <c:pt idx="89">
                  <c:v>739.29311111111122</c:v>
                </c:pt>
                <c:pt idx="90">
                  <c:v>751.24111111111119</c:v>
                </c:pt>
                <c:pt idx="91">
                  <c:v>756.02022222222217</c:v>
                </c:pt>
                <c:pt idx="92">
                  <c:v>756.68400000000008</c:v>
                </c:pt>
                <c:pt idx="93">
                  <c:v>753.49822222222224</c:v>
                </c:pt>
                <c:pt idx="94">
                  <c:v>748.05533333333335</c:v>
                </c:pt>
                <c:pt idx="95">
                  <c:v>740.3555555555555</c:v>
                </c:pt>
                <c:pt idx="96">
                  <c:v>730.13333333333355</c:v>
                </c:pt>
                <c:pt idx="97">
                  <c:v>719.1151111111111</c:v>
                </c:pt>
                <c:pt idx="98">
                  <c:v>706.50333333333344</c:v>
                </c:pt>
                <c:pt idx="99">
                  <c:v>692.96266666666656</c:v>
                </c:pt>
                <c:pt idx="100">
                  <c:v>678.09422222222213</c:v>
                </c:pt>
                <c:pt idx="101">
                  <c:v>661.36777777777775</c:v>
                </c:pt>
                <c:pt idx="102">
                  <c:v>642.91511111111117</c:v>
                </c:pt>
                <c:pt idx="103">
                  <c:v>625.92311111111098</c:v>
                </c:pt>
                <c:pt idx="104">
                  <c:v>613.44444444444446</c:v>
                </c:pt>
                <c:pt idx="105">
                  <c:v>606.67444444444448</c:v>
                </c:pt>
                <c:pt idx="106">
                  <c:v>606.27600000000018</c:v>
                </c:pt>
                <c:pt idx="107">
                  <c:v>609.72733333333338</c:v>
                </c:pt>
                <c:pt idx="108">
                  <c:v>613.70977777777807</c:v>
                </c:pt>
                <c:pt idx="109">
                  <c:v>614.10822222222248</c:v>
                </c:pt>
                <c:pt idx="110">
                  <c:v>611.58577777777805</c:v>
                </c:pt>
                <c:pt idx="111">
                  <c:v>606.80644444444431</c:v>
                </c:pt>
                <c:pt idx="112">
                  <c:v>600.43466666666677</c:v>
                </c:pt>
                <c:pt idx="113">
                  <c:v>594.46066666666661</c:v>
                </c:pt>
                <c:pt idx="114">
                  <c:v>588.61955555555551</c:v>
                </c:pt>
                <c:pt idx="115">
                  <c:v>582.64555555555557</c:v>
                </c:pt>
                <c:pt idx="116">
                  <c:v>576.53911111111108</c:v>
                </c:pt>
                <c:pt idx="117">
                  <c:v>569.76866666666683</c:v>
                </c:pt>
                <c:pt idx="118">
                  <c:v>561.40555555555568</c:v>
                </c:pt>
                <c:pt idx="119">
                  <c:v>551.84755555555546</c:v>
                </c:pt>
                <c:pt idx="120">
                  <c:v>541.62555555555559</c:v>
                </c:pt>
                <c:pt idx="121">
                  <c:v>531.0055555555557</c:v>
                </c:pt>
                <c:pt idx="122">
                  <c:v>520.25244444444445</c:v>
                </c:pt>
                <c:pt idx="123">
                  <c:v>509.49955555555545</c:v>
                </c:pt>
                <c:pt idx="124">
                  <c:v>498.08266666666674</c:v>
                </c:pt>
                <c:pt idx="125">
                  <c:v>485.73711111111112</c:v>
                </c:pt>
                <c:pt idx="126">
                  <c:v>472.06333333333339</c:v>
                </c:pt>
                <c:pt idx="127">
                  <c:v>457.99177777777771</c:v>
                </c:pt>
                <c:pt idx="128">
                  <c:v>444.58422222222225</c:v>
                </c:pt>
                <c:pt idx="129">
                  <c:v>432.63644444444446</c:v>
                </c:pt>
                <c:pt idx="130">
                  <c:v>422.81266666666676</c:v>
                </c:pt>
                <c:pt idx="131">
                  <c:v>414.05155555555552</c:v>
                </c:pt>
                <c:pt idx="132">
                  <c:v>405.55533333333346</c:v>
                </c:pt>
                <c:pt idx="133">
                  <c:v>396.26244444444455</c:v>
                </c:pt>
                <c:pt idx="134">
                  <c:v>385.24422222222228</c:v>
                </c:pt>
                <c:pt idx="135">
                  <c:v>373.18013888888891</c:v>
                </c:pt>
                <c:pt idx="136">
                  <c:v>361.56458333333347</c:v>
                </c:pt>
                <c:pt idx="137">
                  <c:v>352.86980555555562</c:v>
                </c:pt>
                <c:pt idx="138">
                  <c:v>348.35669444444449</c:v>
                </c:pt>
              </c:numCache>
            </c:numRef>
          </c:xVal>
          <c:yVal>
            <c:numRef>
              <c:f>Sheet2!$C$20:$C$180</c:f>
              <c:numCache>
                <c:formatCode>General</c:formatCode>
                <c:ptCount val="161"/>
                <c:pt idx="0">
                  <c:v>118.71950155515283</c:v>
                </c:pt>
                <c:pt idx="3">
                  <c:v>95.939497514204533</c:v>
                </c:pt>
                <c:pt idx="6">
                  <c:v>65.407237787356323</c:v>
                </c:pt>
                <c:pt idx="9">
                  <c:v>28.886130665136182</c:v>
                </c:pt>
                <c:pt idx="16">
                  <c:v>-25.446685504016457</c:v>
                </c:pt>
                <c:pt idx="20">
                  <c:v>-57.40832805508029</c:v>
                </c:pt>
                <c:pt idx="23">
                  <c:v>-62.780321507304549</c:v>
                </c:pt>
                <c:pt idx="26">
                  <c:v>-57.041313812022906</c:v>
                </c:pt>
                <c:pt idx="30">
                  <c:v>-45.902809953941563</c:v>
                </c:pt>
                <c:pt idx="33">
                  <c:v>-27.852695190047026</c:v>
                </c:pt>
                <c:pt idx="37">
                  <c:v>-17.729660560344829</c:v>
                </c:pt>
                <c:pt idx="50">
                  <c:v>-25.812981805371347</c:v>
                </c:pt>
                <c:pt idx="62">
                  <c:v>-19.607194507395036</c:v>
                </c:pt>
                <c:pt idx="77">
                  <c:v>32.31161399592731</c:v>
                </c:pt>
                <c:pt idx="80">
                  <c:v>70.476422991071431</c:v>
                </c:pt>
                <c:pt idx="83">
                  <c:v>140.6027823802502</c:v>
                </c:pt>
                <c:pt idx="87">
                  <c:v>203.6337685751748</c:v>
                </c:pt>
                <c:pt idx="90">
                  <c:v>250.27121637100561</c:v>
                </c:pt>
                <c:pt idx="93">
                  <c:v>291.69894340343046</c:v>
                </c:pt>
                <c:pt idx="97">
                  <c:v>309.5963440573239</c:v>
                </c:pt>
                <c:pt idx="100">
                  <c:v>220.51475542686472</c:v>
                </c:pt>
                <c:pt idx="103">
                  <c:v>171.92404496881528</c:v>
                </c:pt>
                <c:pt idx="107">
                  <c:v>219.92778080508754</c:v>
                </c:pt>
                <c:pt idx="110">
                  <c:v>208.10756065504177</c:v>
                </c:pt>
                <c:pt idx="113">
                  <c:v>186.801239938447</c:v>
                </c:pt>
                <c:pt idx="117">
                  <c:v>185.51580255681816</c:v>
                </c:pt>
                <c:pt idx="120">
                  <c:v>186.7538914535985</c:v>
                </c:pt>
                <c:pt idx="123">
                  <c:v>176.55799730195275</c:v>
                </c:pt>
                <c:pt idx="127">
                  <c:v>182.14213764750878</c:v>
                </c:pt>
                <c:pt idx="130">
                  <c:v>152.15139678030306</c:v>
                </c:pt>
                <c:pt idx="133">
                  <c:v>177.87900982481059</c:v>
                </c:pt>
                <c:pt idx="137">
                  <c:v>150.869658499053</c:v>
                </c:pt>
                <c:pt idx="140">
                  <c:v>105.23052793560606</c:v>
                </c:pt>
                <c:pt idx="143">
                  <c:v>87.776069105204343</c:v>
                </c:pt>
                <c:pt idx="147">
                  <c:v>104.33924392664626</c:v>
                </c:pt>
                <c:pt idx="150">
                  <c:v>118.7195015551528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2836608"/>
        <c:axId val="202854784"/>
      </c:scatterChart>
      <c:valAx>
        <c:axId val="202836608"/>
        <c:scaling>
          <c:orientation val="minMax"/>
          <c:max val="800"/>
          <c:min val="-20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solidFill>
                  <a:schemeClr val="tx1"/>
                </a:solidFill>
              </a:defRPr>
            </a:pPr>
            <a:endParaRPr lang="en-US"/>
          </a:p>
        </c:txPr>
        <c:crossAx val="202854784"/>
        <c:crosses val="autoZero"/>
        <c:crossBetween val="midCat"/>
        <c:majorUnit val="200"/>
      </c:valAx>
      <c:valAx>
        <c:axId val="202854784"/>
        <c:scaling>
          <c:orientation val="minMax"/>
          <c:max val="400"/>
          <c:min val="-10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solidFill>
                  <a:schemeClr val="tx1"/>
                </a:solidFill>
              </a:defRPr>
            </a:pPr>
            <a:endParaRPr lang="en-US"/>
          </a:p>
        </c:txPr>
        <c:crossAx val="202836608"/>
        <c:crosses val="autoZero"/>
        <c:crossBetween val="midCat"/>
        <c:majorUnit val="100"/>
      </c:valAx>
    </c:plotArea>
    <c:plotVisOnly val="1"/>
    <c:dispBlanksAs val="gap"/>
    <c:showDLblsOverMax val="0"/>
  </c:chart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3"/>
            <c:spPr>
              <a:noFill/>
              <a:ln>
                <a:solidFill>
                  <a:schemeClr val="tx1"/>
                </a:solidFill>
              </a:ln>
            </c:spPr>
          </c:marker>
          <c:trendline>
            <c:spPr>
              <a:ln>
                <a:solidFill>
                  <a:schemeClr val="tx1"/>
                </a:solidFill>
              </a:ln>
            </c:spPr>
            <c:trendlineType val="linear"/>
            <c:dispRSqr val="1"/>
            <c:dispEq val="1"/>
            <c:trendlineLbl>
              <c:layout>
                <c:manualLayout>
                  <c:x val="-6.2416897592981496E-2"/>
                  <c:y val="-0.2508019121510594"/>
                </c:manualLayout>
              </c:layout>
              <c:tx>
                <c:rich>
                  <a:bodyPr/>
                  <a:lstStyle/>
                  <a:p>
                    <a:pPr>
                      <a:defRPr sz="1200">
                        <a:solidFill>
                          <a:schemeClr val="tx1"/>
                        </a:solidFill>
                      </a:defRPr>
                    </a:pPr>
                    <a:r>
                      <a:rPr lang="en-US" baseline="0" dirty="0" smtClean="0"/>
                      <a:t>Patient 2  </a:t>
                    </a:r>
                  </a:p>
                  <a:p>
                    <a:pPr>
                      <a:defRPr sz="1200">
                        <a:solidFill>
                          <a:schemeClr val="tx1"/>
                        </a:solidFill>
                      </a:defRPr>
                    </a:pPr>
                    <a:r>
                      <a:rPr lang="en-US" baseline="0" dirty="0" smtClean="0"/>
                      <a:t>r </a:t>
                    </a:r>
                    <a:r>
                      <a:rPr lang="en-US" baseline="0" dirty="0"/>
                      <a:t>= </a:t>
                    </a:r>
                    <a:r>
                      <a:rPr lang="en-US" baseline="0" dirty="0" smtClean="0"/>
                      <a:t>0.96</a:t>
                    </a:r>
                    <a:endParaRPr lang="en-US" dirty="0"/>
                  </a:p>
                </c:rich>
              </c:tx>
              <c:numFmt formatCode="General" sourceLinked="0"/>
            </c:trendlineLbl>
          </c:trendline>
          <c:xVal>
            <c:numRef>
              <c:f>Sheet6!$T$260:$T$304</c:f>
              <c:numCache>
                <c:formatCode>General</c:formatCode>
                <c:ptCount val="45"/>
                <c:pt idx="0">
                  <c:v>181.17919999999998</c:v>
                </c:pt>
                <c:pt idx="1">
                  <c:v>192.96786666666668</c:v>
                </c:pt>
                <c:pt idx="2">
                  <c:v>157.92146666666667</c:v>
                </c:pt>
                <c:pt idx="3">
                  <c:v>143.69093333333336</c:v>
                </c:pt>
                <c:pt idx="5">
                  <c:v>-132.11519999999999</c:v>
                </c:pt>
                <c:pt idx="6">
                  <c:v>-108.11386666666698</c:v>
                </c:pt>
                <c:pt idx="7">
                  <c:v>-89.635466666666687</c:v>
                </c:pt>
                <c:pt idx="8">
                  <c:v>-78.90893333333328</c:v>
                </c:pt>
                <c:pt idx="9">
                  <c:v>-64.359066666666592</c:v>
                </c:pt>
                <c:pt idx="10">
                  <c:v>-64.900000000000006</c:v>
                </c:pt>
                <c:pt idx="11">
                  <c:v>-52.04</c:v>
                </c:pt>
                <c:pt idx="16">
                  <c:v>102.3</c:v>
                </c:pt>
                <c:pt idx="17">
                  <c:v>126.1</c:v>
                </c:pt>
                <c:pt idx="18">
                  <c:v>200.9332</c:v>
                </c:pt>
                <c:pt idx="19">
                  <c:v>317.85960000000006</c:v>
                </c:pt>
                <c:pt idx="20">
                  <c:v>401.86426666666671</c:v>
                </c:pt>
                <c:pt idx="21">
                  <c:v>494.89840000000004</c:v>
                </c:pt>
                <c:pt idx="22">
                  <c:v>552.88400000000001</c:v>
                </c:pt>
                <c:pt idx="23">
                  <c:v>558.61959999999999</c:v>
                </c:pt>
                <c:pt idx="24">
                  <c:v>554.15866666666682</c:v>
                </c:pt>
                <c:pt idx="25">
                  <c:v>555.85693333333336</c:v>
                </c:pt>
                <c:pt idx="26">
                  <c:v>552.14</c:v>
                </c:pt>
                <c:pt idx="27">
                  <c:v>540.35199999999986</c:v>
                </c:pt>
                <c:pt idx="28">
                  <c:v>523.1478666666668</c:v>
                </c:pt>
                <c:pt idx="29">
                  <c:v>502.3330666666667</c:v>
                </c:pt>
                <c:pt idx="30">
                  <c:v>488.73880000000003</c:v>
                </c:pt>
                <c:pt idx="31">
                  <c:v>470.89706666666672</c:v>
                </c:pt>
                <c:pt idx="32">
                  <c:v>447.00093333333342</c:v>
                </c:pt>
                <c:pt idx="33">
                  <c:v>422.04306666666673</c:v>
                </c:pt>
                <c:pt idx="34">
                  <c:v>406.32479999999993</c:v>
                </c:pt>
                <c:pt idx="35">
                  <c:v>397.40386666666666</c:v>
                </c:pt>
                <c:pt idx="36">
                  <c:v>385.50933333333336</c:v>
                </c:pt>
                <c:pt idx="37">
                  <c:v>373.82693333333344</c:v>
                </c:pt>
                <c:pt idx="38">
                  <c:v>371.17133333333351</c:v>
                </c:pt>
                <c:pt idx="39">
                  <c:v>368.72853333333342</c:v>
                </c:pt>
                <c:pt idx="40">
                  <c:v>367.98560000000009</c:v>
                </c:pt>
                <c:pt idx="41">
                  <c:v>363.63146666666671</c:v>
                </c:pt>
                <c:pt idx="42">
                  <c:v>354.39226666666679</c:v>
                </c:pt>
                <c:pt idx="43">
                  <c:v>330.07226666666674</c:v>
                </c:pt>
                <c:pt idx="44">
                  <c:v>282.60079999999999</c:v>
                </c:pt>
              </c:numCache>
            </c:numRef>
          </c:xVal>
          <c:yVal>
            <c:numRef>
              <c:f>Sheet6!$U$260:$U$304</c:f>
              <c:numCache>
                <c:formatCode>General</c:formatCode>
                <c:ptCount val="45"/>
                <c:pt idx="0">
                  <c:v>38.828723668555774</c:v>
                </c:pt>
                <c:pt idx="1">
                  <c:v>75.157147252001238</c:v>
                </c:pt>
                <c:pt idx="2">
                  <c:v>45.227644824886653</c:v>
                </c:pt>
                <c:pt idx="3">
                  <c:v>33.55771905035116</c:v>
                </c:pt>
                <c:pt idx="5">
                  <c:v>-27.641099064129342</c:v>
                </c:pt>
                <c:pt idx="6">
                  <c:v>-53.710634767067269</c:v>
                </c:pt>
                <c:pt idx="7">
                  <c:v>-56.435827906313975</c:v>
                </c:pt>
                <c:pt idx="8">
                  <c:v>-35.1751573172427</c:v>
                </c:pt>
                <c:pt idx="9">
                  <c:v>-37.672121195862871</c:v>
                </c:pt>
                <c:pt idx="10">
                  <c:v>-23.555426808724704</c:v>
                </c:pt>
                <c:pt idx="11">
                  <c:v>-29.480125959292625</c:v>
                </c:pt>
                <c:pt idx="16">
                  <c:v>26.852169552364863</c:v>
                </c:pt>
                <c:pt idx="17">
                  <c:v>18.459274080052591</c:v>
                </c:pt>
                <c:pt idx="18">
                  <c:v>54.17902578551913</c:v>
                </c:pt>
                <c:pt idx="19">
                  <c:v>66.068652444709073</c:v>
                </c:pt>
                <c:pt idx="20">
                  <c:v>109.04622909340311</c:v>
                </c:pt>
                <c:pt idx="21">
                  <c:v>171.79466356405067</c:v>
                </c:pt>
                <c:pt idx="22">
                  <c:v>235.27603433495713</c:v>
                </c:pt>
                <c:pt idx="23">
                  <c:v>235.23578228013085</c:v>
                </c:pt>
                <c:pt idx="24">
                  <c:v>264.69078573152228</c:v>
                </c:pt>
                <c:pt idx="25">
                  <c:v>222.38450673581826</c:v>
                </c:pt>
                <c:pt idx="26">
                  <c:v>224.56989438529206</c:v>
                </c:pt>
                <c:pt idx="27">
                  <c:v>231.23904087013841</c:v>
                </c:pt>
                <c:pt idx="28">
                  <c:v>233.95317442774655</c:v>
                </c:pt>
                <c:pt idx="29">
                  <c:v>228.58245346993041</c:v>
                </c:pt>
                <c:pt idx="30">
                  <c:v>210.1221123549324</c:v>
                </c:pt>
                <c:pt idx="31">
                  <c:v>185.60680259146338</c:v>
                </c:pt>
                <c:pt idx="32">
                  <c:v>170.54740893339479</c:v>
                </c:pt>
                <c:pt idx="33">
                  <c:v>159.75572833836307</c:v>
                </c:pt>
                <c:pt idx="34">
                  <c:v>140.6828825617624</c:v>
                </c:pt>
                <c:pt idx="35">
                  <c:v>114.39773785376049</c:v>
                </c:pt>
                <c:pt idx="36">
                  <c:v>107.85638992924791</c:v>
                </c:pt>
                <c:pt idx="37">
                  <c:v>103.20979449928926</c:v>
                </c:pt>
                <c:pt idx="38">
                  <c:v>106.88694579611774</c:v>
                </c:pt>
                <c:pt idx="39">
                  <c:v>121.63136095177327</c:v>
                </c:pt>
                <c:pt idx="40">
                  <c:v>121.0343032902267</c:v>
                </c:pt>
                <c:pt idx="41">
                  <c:v>128.63174451642041</c:v>
                </c:pt>
                <c:pt idx="42">
                  <c:v>129.55324739121806</c:v>
                </c:pt>
                <c:pt idx="43">
                  <c:v>131.55970920331188</c:v>
                </c:pt>
                <c:pt idx="44">
                  <c:v>142.8060050156458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2876416"/>
        <c:axId val="202877952"/>
      </c:scatterChart>
      <c:valAx>
        <c:axId val="202876416"/>
        <c:scaling>
          <c:orientation val="minMax"/>
          <c:max val="800"/>
          <c:min val="-20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solidFill>
                  <a:schemeClr val="tx1"/>
                </a:solidFill>
              </a:defRPr>
            </a:pPr>
            <a:endParaRPr lang="en-US"/>
          </a:p>
        </c:txPr>
        <c:crossAx val="202877952"/>
        <c:crosses val="autoZero"/>
        <c:crossBetween val="midCat"/>
        <c:majorUnit val="200"/>
      </c:valAx>
      <c:valAx>
        <c:axId val="202877952"/>
        <c:scaling>
          <c:orientation val="minMax"/>
          <c:max val="400"/>
          <c:min val="-10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solidFill>
                  <a:schemeClr val="tx1"/>
                </a:solidFill>
              </a:defRPr>
            </a:pPr>
            <a:endParaRPr lang="en-US"/>
          </a:p>
        </c:txPr>
        <c:crossAx val="202876416"/>
        <c:crosses val="autoZero"/>
        <c:crossBetween val="midCat"/>
        <c:majorUnit val="100"/>
      </c:valAx>
    </c:plotArea>
    <c:plotVisOnly val="1"/>
    <c:dispBlanksAs val="gap"/>
    <c:showDLblsOverMax val="0"/>
  </c:chart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3"/>
            <c:spPr>
              <a:noFill/>
              <a:ln>
                <a:solidFill>
                  <a:schemeClr val="tx1"/>
                </a:solidFill>
              </a:ln>
            </c:spPr>
          </c:marker>
          <c:trendline>
            <c:spPr>
              <a:ln>
                <a:solidFill>
                  <a:schemeClr val="tx1"/>
                </a:solidFill>
              </a:ln>
            </c:spPr>
            <c:trendlineType val="linear"/>
            <c:dispRSqr val="1"/>
            <c:dispEq val="1"/>
            <c:trendlineLbl>
              <c:layout>
                <c:manualLayout>
                  <c:x val="-0.21469472759828476"/>
                  <c:y val="-0.1449892416505269"/>
                </c:manualLayout>
              </c:layout>
              <c:tx>
                <c:rich>
                  <a:bodyPr/>
                  <a:lstStyle/>
                  <a:p>
                    <a:pPr>
                      <a:defRPr sz="1200">
                        <a:solidFill>
                          <a:schemeClr val="tx1"/>
                        </a:solidFill>
                      </a:defRPr>
                    </a:pPr>
                    <a:r>
                      <a:rPr lang="en-US" baseline="0" dirty="0" smtClean="0"/>
                      <a:t>Patient 3 </a:t>
                    </a:r>
                  </a:p>
                  <a:p>
                    <a:pPr>
                      <a:defRPr sz="1200">
                        <a:solidFill>
                          <a:schemeClr val="tx1"/>
                        </a:solidFill>
                      </a:defRPr>
                    </a:pPr>
                    <a:r>
                      <a:rPr lang="en-US" baseline="0" dirty="0" smtClean="0"/>
                      <a:t>r </a:t>
                    </a:r>
                    <a:r>
                      <a:rPr lang="en-US" baseline="0" dirty="0"/>
                      <a:t>= </a:t>
                    </a:r>
                    <a:r>
                      <a:rPr lang="en-US" baseline="0" dirty="0" smtClean="0"/>
                      <a:t>0.97</a:t>
                    </a:r>
                    <a:endParaRPr lang="en-US" dirty="0"/>
                  </a:p>
                </c:rich>
              </c:tx>
              <c:numFmt formatCode="General" sourceLinked="0"/>
            </c:trendlineLbl>
          </c:trendline>
          <c:xVal>
            <c:numRef>
              <c:f>Sheet2!$F$12:$F$193</c:f>
              <c:numCache>
                <c:formatCode>General</c:formatCode>
                <c:ptCount val="182"/>
                <c:pt idx="0">
                  <c:v>363.60616666666675</c:v>
                </c:pt>
                <c:pt idx="1">
                  <c:v>366.19466666666676</c:v>
                </c:pt>
                <c:pt idx="2">
                  <c:v>370.7748333333335</c:v>
                </c:pt>
                <c:pt idx="3">
                  <c:v>377.34633333333346</c:v>
                </c:pt>
                <c:pt idx="4">
                  <c:v>384.11666666666673</c:v>
                </c:pt>
                <c:pt idx="5">
                  <c:v>390.28950000000009</c:v>
                </c:pt>
                <c:pt idx="6">
                  <c:v>393.87366666666674</c:v>
                </c:pt>
                <c:pt idx="7">
                  <c:v>395.2671666666667</c:v>
                </c:pt>
                <c:pt idx="8">
                  <c:v>395.46583333333342</c:v>
                </c:pt>
                <c:pt idx="9">
                  <c:v>394.66883333333345</c:v>
                </c:pt>
                <c:pt idx="10">
                  <c:v>390.48699999999997</c:v>
                </c:pt>
                <c:pt idx="11">
                  <c:v>383.71716666666674</c:v>
                </c:pt>
                <c:pt idx="12">
                  <c:v>372.76566666666673</c:v>
                </c:pt>
                <c:pt idx="13">
                  <c:v>354.24683333333354</c:v>
                </c:pt>
                <c:pt idx="14">
                  <c:v>331.74583333333345</c:v>
                </c:pt>
                <c:pt idx="15">
                  <c:v>303.47016666666667</c:v>
                </c:pt>
                <c:pt idx="25">
                  <c:v>116.2906666666667</c:v>
                </c:pt>
                <c:pt idx="31">
                  <c:v>-105.33883333333299</c:v>
                </c:pt>
                <c:pt idx="32">
                  <c:v>-104.54216666666701</c:v>
                </c:pt>
                <c:pt idx="33">
                  <c:v>-103.546333333333</c:v>
                </c:pt>
                <c:pt idx="34">
                  <c:v>-104.740833333333</c:v>
                </c:pt>
                <c:pt idx="35">
                  <c:v>-106.53283333333299</c:v>
                </c:pt>
                <c:pt idx="36">
                  <c:v>-109.91800000000002</c:v>
                </c:pt>
                <c:pt idx="37">
                  <c:v>-112.904833333333</c:v>
                </c:pt>
                <c:pt idx="38">
                  <c:v>-117.28566666666701</c:v>
                </c:pt>
                <c:pt idx="39">
                  <c:v>-121.86566666666701</c:v>
                </c:pt>
                <c:pt idx="40">
                  <c:v>-127.04300000000002</c:v>
                </c:pt>
                <c:pt idx="41">
                  <c:v>-133.81333333333299</c:v>
                </c:pt>
                <c:pt idx="42">
                  <c:v>-140.78300000000002</c:v>
                </c:pt>
                <c:pt idx="43">
                  <c:v>-145.96033333333304</c:v>
                </c:pt>
                <c:pt idx="44">
                  <c:v>-148.94716666666699</c:v>
                </c:pt>
                <c:pt idx="45">
                  <c:v>-147.354166666667</c:v>
                </c:pt>
                <c:pt idx="46">
                  <c:v>-140.58383333333299</c:v>
                </c:pt>
                <c:pt idx="47">
                  <c:v>-129.83100000000002</c:v>
                </c:pt>
                <c:pt idx="48">
                  <c:v>-116.688666666667</c:v>
                </c:pt>
                <c:pt idx="49">
                  <c:v>-104.14366666666702</c:v>
                </c:pt>
                <c:pt idx="50">
                  <c:v>-91.798000000000002</c:v>
                </c:pt>
                <c:pt idx="53">
                  <c:v>68.102166666666648</c:v>
                </c:pt>
                <c:pt idx="54">
                  <c:v>61.929500000000012</c:v>
                </c:pt>
                <c:pt idx="55">
                  <c:v>58.94250000000001</c:v>
                </c:pt>
                <c:pt idx="56">
                  <c:v>55.756333333333338</c:v>
                </c:pt>
                <c:pt idx="57">
                  <c:v>53.56600000000001</c:v>
                </c:pt>
                <c:pt idx="58">
                  <c:v>51.773833333333336</c:v>
                </c:pt>
                <c:pt idx="59">
                  <c:v>50.778166666666657</c:v>
                </c:pt>
                <c:pt idx="60">
                  <c:v>50.778166666666657</c:v>
                </c:pt>
                <c:pt idx="61">
                  <c:v>51.574666666666644</c:v>
                </c:pt>
                <c:pt idx="62">
                  <c:v>54.362500000000004</c:v>
                </c:pt>
                <c:pt idx="63">
                  <c:v>58.34483333333332</c:v>
                </c:pt>
                <c:pt idx="64">
                  <c:v>64.716499999999996</c:v>
                </c:pt>
                <c:pt idx="65">
                  <c:v>71.088333333333324</c:v>
                </c:pt>
                <c:pt idx="66">
                  <c:v>77.858499999999978</c:v>
                </c:pt>
                <c:pt idx="67">
                  <c:v>84.230333333333306</c:v>
                </c:pt>
                <c:pt idx="68">
                  <c:v>89.805833333333297</c:v>
                </c:pt>
                <c:pt idx="69">
                  <c:v>94.385833333333295</c:v>
                </c:pt>
                <c:pt idx="70">
                  <c:v>98.766666666666666</c:v>
                </c:pt>
                <c:pt idx="71">
                  <c:v>102.74916666666667</c:v>
                </c:pt>
                <c:pt idx="72">
                  <c:v>106.33349999999999</c:v>
                </c:pt>
                <c:pt idx="73">
                  <c:v>110.91366666666667</c:v>
                </c:pt>
                <c:pt idx="74">
                  <c:v>115.09549999999999</c:v>
                </c:pt>
                <c:pt idx="75">
                  <c:v>118.87916666666665</c:v>
                </c:pt>
                <c:pt idx="76">
                  <c:v>122.26466666666667</c:v>
                </c:pt>
                <c:pt idx="77">
                  <c:v>125.45083333333331</c:v>
                </c:pt>
                <c:pt idx="78">
                  <c:v>126.84466666666668</c:v>
                </c:pt>
                <c:pt idx="79">
                  <c:v>129.23433333333338</c:v>
                </c:pt>
                <c:pt idx="80">
                  <c:v>133.01783333333339</c:v>
                </c:pt>
                <c:pt idx="81">
                  <c:v>138.9916666666667</c:v>
                </c:pt>
                <c:pt idx="82">
                  <c:v>148.15150000000003</c:v>
                </c:pt>
                <c:pt idx="83">
                  <c:v>160.09916666666666</c:v>
                </c:pt>
                <c:pt idx="84">
                  <c:v>174.43633333333341</c:v>
                </c:pt>
                <c:pt idx="85">
                  <c:v>189.57</c:v>
                </c:pt>
                <c:pt idx="86">
                  <c:v>206.09766666666661</c:v>
                </c:pt>
                <c:pt idx="87">
                  <c:v>223.62100000000001</c:v>
                </c:pt>
                <c:pt idx="88">
                  <c:v>241.34333333333336</c:v>
                </c:pt>
                <c:pt idx="89">
                  <c:v>258.26916666666671</c:v>
                </c:pt>
                <c:pt idx="90">
                  <c:v>274.99583333333345</c:v>
                </c:pt>
                <c:pt idx="91">
                  <c:v>292.71799999999996</c:v>
                </c:pt>
                <c:pt idx="92">
                  <c:v>309.64383333333348</c:v>
                </c:pt>
                <c:pt idx="93">
                  <c:v>329.95466666666675</c:v>
                </c:pt>
                <c:pt idx="94">
                  <c:v>354.0488333333335</c:v>
                </c:pt>
                <c:pt idx="95">
                  <c:v>377.34666666666681</c:v>
                </c:pt>
                <c:pt idx="96">
                  <c:v>402.03833333333336</c:v>
                </c:pt>
                <c:pt idx="97">
                  <c:v>430.51316666666673</c:v>
                </c:pt>
                <c:pt idx="98">
                  <c:v>456.99700000000013</c:v>
                </c:pt>
                <c:pt idx="99">
                  <c:v>483.68033333333346</c:v>
                </c:pt>
                <c:pt idx="100">
                  <c:v>513.3504999999999</c:v>
                </c:pt>
                <c:pt idx="101">
                  <c:v>542.4233333333334</c:v>
                </c:pt>
                <c:pt idx="102">
                  <c:v>568.11133333333339</c:v>
                </c:pt>
                <c:pt idx="103">
                  <c:v>592.40533333333349</c:v>
                </c:pt>
                <c:pt idx="104">
                  <c:v>614.70749999999998</c:v>
                </c:pt>
                <c:pt idx="105">
                  <c:v>634.42066666666665</c:v>
                </c:pt>
                <c:pt idx="106">
                  <c:v>651.346</c:v>
                </c:pt>
                <c:pt idx="107">
                  <c:v>665.88183333333359</c:v>
                </c:pt>
                <c:pt idx="108">
                  <c:v>678.82450000000006</c:v>
                </c:pt>
                <c:pt idx="109">
                  <c:v>687.7850000000002</c:v>
                </c:pt>
                <c:pt idx="110">
                  <c:v>696.34766666666678</c:v>
                </c:pt>
                <c:pt idx="111">
                  <c:v>702.72</c:v>
                </c:pt>
                <c:pt idx="112">
                  <c:v>708.6938333333336</c:v>
                </c:pt>
                <c:pt idx="113">
                  <c:v>714.66783333333319</c:v>
                </c:pt>
                <c:pt idx="114">
                  <c:v>719.44699999999978</c:v>
                </c:pt>
                <c:pt idx="115">
                  <c:v>725.42066666666665</c:v>
                </c:pt>
                <c:pt idx="116">
                  <c:v>730.99633333333338</c:v>
                </c:pt>
                <c:pt idx="117">
                  <c:v>735.17816666666681</c:v>
                </c:pt>
                <c:pt idx="118">
                  <c:v>737.96599999999989</c:v>
                </c:pt>
                <c:pt idx="119">
                  <c:v>738.96166666666682</c:v>
                </c:pt>
                <c:pt idx="120">
                  <c:v>736.97050000000013</c:v>
                </c:pt>
                <c:pt idx="121">
                  <c:v>733.98350000000005</c:v>
                </c:pt>
                <c:pt idx="122">
                  <c:v>731.19583333333355</c:v>
                </c:pt>
                <c:pt idx="123">
                  <c:v>728.40849999999989</c:v>
                </c:pt>
                <c:pt idx="124">
                  <c:v>728.4086666666667</c:v>
                </c:pt>
                <c:pt idx="125">
                  <c:v>728.4088333333334</c:v>
                </c:pt>
                <c:pt idx="126">
                  <c:v>729.20533333333356</c:v>
                </c:pt>
                <c:pt idx="127">
                  <c:v>729.40400000000022</c:v>
                </c:pt>
                <c:pt idx="128">
                  <c:v>727.21316666666701</c:v>
                </c:pt>
                <c:pt idx="129">
                  <c:v>721.8365</c:v>
                </c:pt>
                <c:pt idx="130">
                  <c:v>714.86666666666679</c:v>
                </c:pt>
                <c:pt idx="131">
                  <c:v>705.10933333333355</c:v>
                </c:pt>
                <c:pt idx="132">
                  <c:v>696.14883333333353</c:v>
                </c:pt>
                <c:pt idx="133">
                  <c:v>689.976</c:v>
                </c:pt>
                <c:pt idx="134">
                  <c:v>684.40049999999997</c:v>
                </c:pt>
                <c:pt idx="135">
                  <c:v>680.21899999999994</c:v>
                </c:pt>
                <c:pt idx="136">
                  <c:v>674.24533333333341</c:v>
                </c:pt>
                <c:pt idx="137">
                  <c:v>667.67400000000009</c:v>
                </c:pt>
                <c:pt idx="138">
                  <c:v>658.91199999999992</c:v>
                </c:pt>
                <c:pt idx="139">
                  <c:v>650.74733333333347</c:v>
                </c:pt>
                <c:pt idx="140">
                  <c:v>642.58300000000031</c:v>
                </c:pt>
                <c:pt idx="141">
                  <c:v>637.8041666666669</c:v>
                </c:pt>
                <c:pt idx="142">
                  <c:v>630.43700000000001</c:v>
                </c:pt>
                <c:pt idx="143">
                  <c:v>625.06133333333332</c:v>
                </c:pt>
                <c:pt idx="144">
                  <c:v>619.28750000000002</c:v>
                </c:pt>
                <c:pt idx="145">
                  <c:v>614.70799999999997</c:v>
                </c:pt>
                <c:pt idx="146">
                  <c:v>612.11933333333343</c:v>
                </c:pt>
                <c:pt idx="147">
                  <c:v>613.31399999999996</c:v>
                </c:pt>
                <c:pt idx="148">
                  <c:v>614.50833333333333</c:v>
                </c:pt>
                <c:pt idx="149">
                  <c:v>616.49900000000002</c:v>
                </c:pt>
                <c:pt idx="150">
                  <c:v>617.29516666666666</c:v>
                </c:pt>
                <c:pt idx="151">
                  <c:v>616.49849999999992</c:v>
                </c:pt>
                <c:pt idx="152">
                  <c:v>615.30349999999999</c:v>
                </c:pt>
                <c:pt idx="153">
                  <c:v>613.51133333333325</c:v>
                </c:pt>
                <c:pt idx="154">
                  <c:v>612.9141666666668</c:v>
                </c:pt>
                <c:pt idx="155">
                  <c:v>611.3209999999998</c:v>
                </c:pt>
                <c:pt idx="156">
                  <c:v>610.32499999999982</c:v>
                </c:pt>
                <c:pt idx="157">
                  <c:v>608.33366666666655</c:v>
                </c:pt>
                <c:pt idx="158">
                  <c:v>605.94416666666655</c:v>
                </c:pt>
                <c:pt idx="159">
                  <c:v>602.75799999999981</c:v>
                </c:pt>
                <c:pt idx="160">
                  <c:v>599.5721666666667</c:v>
                </c:pt>
                <c:pt idx="161">
                  <c:v>596.38616666666655</c:v>
                </c:pt>
                <c:pt idx="162">
                  <c:v>593.19983333333346</c:v>
                </c:pt>
                <c:pt idx="163">
                  <c:v>590.41199999999992</c:v>
                </c:pt>
                <c:pt idx="164">
                  <c:v>587.02699999999993</c:v>
                </c:pt>
                <c:pt idx="165">
                  <c:v>584.83683333333329</c:v>
                </c:pt>
                <c:pt idx="166">
                  <c:v>582.44783333333339</c:v>
                </c:pt>
                <c:pt idx="167">
                  <c:v>578.66499999999996</c:v>
                </c:pt>
                <c:pt idx="168">
                  <c:v>573.68716666666671</c:v>
                </c:pt>
                <c:pt idx="169">
                  <c:v>568.70933333333346</c:v>
                </c:pt>
                <c:pt idx="170">
                  <c:v>561.34166666666658</c:v>
                </c:pt>
                <c:pt idx="171">
                  <c:v>553.97366666666676</c:v>
                </c:pt>
                <c:pt idx="172">
                  <c:v>546.60566666666671</c:v>
                </c:pt>
                <c:pt idx="173">
                  <c:v>538.83949999999982</c:v>
                </c:pt>
                <c:pt idx="174">
                  <c:v>529.67933333333349</c:v>
                </c:pt>
                <c:pt idx="175">
                  <c:v>519.12516666666681</c:v>
                </c:pt>
                <c:pt idx="176">
                  <c:v>506.77916666666658</c:v>
                </c:pt>
                <c:pt idx="177">
                  <c:v>492.44200000000001</c:v>
                </c:pt>
                <c:pt idx="178">
                  <c:v>478.10450000000014</c:v>
                </c:pt>
                <c:pt idx="179">
                  <c:v>466.68761111111121</c:v>
                </c:pt>
                <c:pt idx="180">
                  <c:v>455.86816666666675</c:v>
                </c:pt>
                <c:pt idx="181">
                  <c:v>446.80758333333353</c:v>
                </c:pt>
              </c:numCache>
            </c:numRef>
          </c:xVal>
          <c:yVal>
            <c:numRef>
              <c:f>Sheet2!$G$12:$G$190</c:f>
              <c:numCache>
                <c:formatCode>General</c:formatCode>
                <c:ptCount val="179"/>
                <c:pt idx="0">
                  <c:v>272.2806490384616</c:v>
                </c:pt>
                <c:pt idx="3">
                  <c:v>203.54828987641488</c:v>
                </c:pt>
                <c:pt idx="6">
                  <c:v>165.14205386275694</c:v>
                </c:pt>
                <c:pt idx="9">
                  <c:v>126.22529380341878</c:v>
                </c:pt>
                <c:pt idx="12">
                  <c:v>80.860739796286666</c:v>
                </c:pt>
                <c:pt idx="15">
                  <c:v>33.6368102174103</c:v>
                </c:pt>
                <c:pt idx="25">
                  <c:v>25.199078135921486</c:v>
                </c:pt>
                <c:pt idx="31">
                  <c:v>-35.881584288356237</c:v>
                </c:pt>
                <c:pt idx="34">
                  <c:v>-76.121176373384216</c:v>
                </c:pt>
                <c:pt idx="37">
                  <c:v>-74.614847117456847</c:v>
                </c:pt>
                <c:pt idx="41">
                  <c:v>-83.362932395710914</c:v>
                </c:pt>
                <c:pt idx="44">
                  <c:v>-66.737209849547668</c:v>
                </c:pt>
                <c:pt idx="47">
                  <c:v>-25.548704503782623</c:v>
                </c:pt>
                <c:pt idx="50">
                  <c:v>-30.023645941614692</c:v>
                </c:pt>
                <c:pt idx="53">
                  <c:v>21.22474249045241</c:v>
                </c:pt>
                <c:pt idx="57">
                  <c:v>34.523090940804948</c:v>
                </c:pt>
                <c:pt idx="60">
                  <c:v>49.22305033346926</c:v>
                </c:pt>
                <c:pt idx="63">
                  <c:v>59.561432625687125</c:v>
                </c:pt>
                <c:pt idx="66">
                  <c:v>57.114640064363918</c:v>
                </c:pt>
                <c:pt idx="69">
                  <c:v>63.81021571451258</c:v>
                </c:pt>
                <c:pt idx="72">
                  <c:v>62.573541089166078</c:v>
                </c:pt>
                <c:pt idx="75">
                  <c:v>41.22952677219245</c:v>
                </c:pt>
                <c:pt idx="79">
                  <c:v>50.607279895736248</c:v>
                </c:pt>
                <c:pt idx="82">
                  <c:v>97.905973882536358</c:v>
                </c:pt>
                <c:pt idx="85">
                  <c:v>130.83785408004158</c:v>
                </c:pt>
                <c:pt idx="88">
                  <c:v>176.10300354440977</c:v>
                </c:pt>
                <c:pt idx="91">
                  <c:v>197.64970800127045</c:v>
                </c:pt>
                <c:pt idx="94">
                  <c:v>256.61308238801848</c:v>
                </c:pt>
                <c:pt idx="98">
                  <c:v>252.96918685927309</c:v>
                </c:pt>
                <c:pt idx="101">
                  <c:v>261.36813630373371</c:v>
                </c:pt>
                <c:pt idx="104">
                  <c:v>332.04038623960497</c:v>
                </c:pt>
                <c:pt idx="107">
                  <c:v>388.26462204391896</c:v>
                </c:pt>
                <c:pt idx="110">
                  <c:v>359.99781966069321</c:v>
                </c:pt>
                <c:pt idx="114">
                  <c:v>410.97670223072339</c:v>
                </c:pt>
                <c:pt idx="117">
                  <c:v>381.4034662667475</c:v>
                </c:pt>
                <c:pt idx="120">
                  <c:v>375.69222758245536</c:v>
                </c:pt>
                <c:pt idx="123">
                  <c:v>340.07974887625966</c:v>
                </c:pt>
                <c:pt idx="126">
                  <c:v>380.90097788217895</c:v>
                </c:pt>
                <c:pt idx="129">
                  <c:v>360.09532481700444</c:v>
                </c:pt>
                <c:pt idx="133">
                  <c:v>331.36737445453264</c:v>
                </c:pt>
                <c:pt idx="136">
                  <c:v>367.62985414361026</c:v>
                </c:pt>
                <c:pt idx="139">
                  <c:v>358.66421631086916</c:v>
                </c:pt>
                <c:pt idx="142">
                  <c:v>398.57897636217939</c:v>
                </c:pt>
                <c:pt idx="145">
                  <c:v>364.02196216649332</c:v>
                </c:pt>
                <c:pt idx="148">
                  <c:v>371.90647099032299</c:v>
                </c:pt>
                <c:pt idx="152">
                  <c:v>355.11605731332298</c:v>
                </c:pt>
                <c:pt idx="154">
                  <c:v>301.3009328439016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9361152"/>
        <c:axId val="189362944"/>
      </c:scatterChart>
      <c:valAx>
        <c:axId val="189361152"/>
        <c:scaling>
          <c:orientation val="minMax"/>
          <c:max val="800"/>
          <c:min val="-20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solidFill>
                  <a:schemeClr val="tx1"/>
                </a:solidFill>
              </a:defRPr>
            </a:pPr>
            <a:endParaRPr lang="en-US"/>
          </a:p>
        </c:txPr>
        <c:crossAx val="189362944"/>
        <c:crosses val="autoZero"/>
        <c:crossBetween val="midCat"/>
        <c:majorUnit val="200"/>
      </c:valAx>
      <c:valAx>
        <c:axId val="189362944"/>
        <c:scaling>
          <c:orientation val="minMax"/>
          <c:max val="400"/>
          <c:min val="-10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solidFill>
                  <a:schemeClr val="tx1"/>
                </a:solidFill>
              </a:defRPr>
            </a:pPr>
            <a:endParaRPr lang="en-US"/>
          </a:p>
        </c:txPr>
        <c:crossAx val="189361152"/>
        <c:crosses val="autoZero"/>
        <c:crossBetween val="midCat"/>
        <c:majorUnit val="100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3"/>
            <c:spPr>
              <a:noFill/>
              <a:ln>
                <a:solidFill>
                  <a:schemeClr val="tx1"/>
                </a:solidFill>
              </a:ln>
            </c:spPr>
          </c:marker>
          <c:trendline>
            <c:spPr>
              <a:ln>
                <a:solidFill>
                  <a:schemeClr val="tx1"/>
                </a:solidFill>
              </a:ln>
            </c:spPr>
            <c:trendlineType val="linear"/>
            <c:dispRSqr val="1"/>
            <c:dispEq val="1"/>
            <c:trendlineLbl>
              <c:layout>
                <c:manualLayout>
                  <c:x val="-9.6228394631639638E-2"/>
                  <c:y val="-0.20193168993932925"/>
                </c:manualLayout>
              </c:layout>
              <c:tx>
                <c:rich>
                  <a:bodyPr/>
                  <a:lstStyle/>
                  <a:p>
                    <a:pPr>
                      <a:defRPr sz="1200">
                        <a:solidFill>
                          <a:schemeClr val="tx1"/>
                        </a:solidFill>
                      </a:defRPr>
                    </a:pPr>
                    <a:r>
                      <a:rPr lang="en-US" baseline="0" dirty="0" smtClean="0"/>
                      <a:t>Patient 4</a:t>
                    </a:r>
                  </a:p>
                  <a:p>
                    <a:pPr>
                      <a:defRPr sz="1200">
                        <a:solidFill>
                          <a:schemeClr val="tx1"/>
                        </a:solidFill>
                      </a:defRPr>
                    </a:pPr>
                    <a:r>
                      <a:rPr lang="en-US" baseline="0" dirty="0" smtClean="0"/>
                      <a:t>r </a:t>
                    </a:r>
                    <a:r>
                      <a:rPr lang="en-US" baseline="0" dirty="0"/>
                      <a:t>= </a:t>
                    </a:r>
                    <a:r>
                      <a:rPr lang="en-US" baseline="0" dirty="0" smtClean="0"/>
                      <a:t>0.91</a:t>
                    </a:r>
                    <a:endParaRPr lang="en-US" dirty="0"/>
                  </a:p>
                </c:rich>
              </c:tx>
              <c:numFmt formatCode="General" sourceLinked="0"/>
            </c:trendlineLbl>
          </c:trendline>
          <c:xVal>
            <c:numRef>
              <c:f>Sheet6!$E$250:$E$295</c:f>
              <c:numCache>
                <c:formatCode>General</c:formatCode>
                <c:ptCount val="46"/>
                <c:pt idx="0">
                  <c:v>119.477</c:v>
                </c:pt>
                <c:pt idx="1">
                  <c:v>71.686999999999998</c:v>
                </c:pt>
                <c:pt idx="2">
                  <c:v>107.529</c:v>
                </c:pt>
                <c:pt idx="3">
                  <c:v>136.20299999999997</c:v>
                </c:pt>
                <c:pt idx="4">
                  <c:v>117.08900000000003</c:v>
                </c:pt>
                <c:pt idx="5">
                  <c:v>122.66300000000001</c:v>
                </c:pt>
                <c:pt idx="6">
                  <c:v>129.036</c:v>
                </c:pt>
                <c:pt idx="7">
                  <c:v>127.44200000000002</c:v>
                </c:pt>
                <c:pt idx="8">
                  <c:v>119.47599999999997</c:v>
                </c:pt>
                <c:pt idx="9">
                  <c:v>115.49400000000001</c:v>
                </c:pt>
                <c:pt idx="10">
                  <c:v>117.88300000000001</c:v>
                </c:pt>
                <c:pt idx="11">
                  <c:v>96.378999999999976</c:v>
                </c:pt>
                <c:pt idx="12">
                  <c:v>83.634999999999991</c:v>
                </c:pt>
                <c:pt idx="13">
                  <c:v>63.724000000000004</c:v>
                </c:pt>
                <c:pt idx="14">
                  <c:v>43.809999999999995</c:v>
                </c:pt>
                <c:pt idx="15">
                  <c:v>30.270000000000003</c:v>
                </c:pt>
                <c:pt idx="16">
                  <c:v>32.660000000000011</c:v>
                </c:pt>
                <c:pt idx="17">
                  <c:v>39.828000000000003</c:v>
                </c:pt>
                <c:pt idx="18">
                  <c:v>86.82</c:v>
                </c:pt>
                <c:pt idx="19">
                  <c:v>115.49400000000001</c:v>
                </c:pt>
                <c:pt idx="20">
                  <c:v>142.57500000000002</c:v>
                </c:pt>
                <c:pt idx="21">
                  <c:v>163.28399999999999</c:v>
                </c:pt>
                <c:pt idx="22">
                  <c:v>184.79</c:v>
                </c:pt>
                <c:pt idx="23">
                  <c:v>232.58100000000002</c:v>
                </c:pt>
                <c:pt idx="24">
                  <c:v>283.5569999999999</c:v>
                </c:pt>
                <c:pt idx="25">
                  <c:v>326.56666666666672</c:v>
                </c:pt>
                <c:pt idx="26">
                  <c:v>347.80666666666667</c:v>
                </c:pt>
                <c:pt idx="27">
                  <c:v>354.88777777777773</c:v>
                </c:pt>
                <c:pt idx="28">
                  <c:v>354.88666666666671</c:v>
                </c:pt>
                <c:pt idx="29">
                  <c:v>357.54444444444437</c:v>
                </c:pt>
                <c:pt idx="30">
                  <c:v>346.92222222222222</c:v>
                </c:pt>
                <c:pt idx="31">
                  <c:v>349.57555555555552</c:v>
                </c:pt>
                <c:pt idx="32">
                  <c:v>345.15111111111111</c:v>
                </c:pt>
                <c:pt idx="33">
                  <c:v>343.38111111111107</c:v>
                </c:pt>
                <c:pt idx="34">
                  <c:v>331.87777777777768</c:v>
                </c:pt>
                <c:pt idx="35">
                  <c:v>322.14333333333337</c:v>
                </c:pt>
                <c:pt idx="36">
                  <c:v>289.39777777777778</c:v>
                </c:pt>
                <c:pt idx="37">
                  <c:v>271.69777777777773</c:v>
                </c:pt>
                <c:pt idx="38">
                  <c:v>247.80222222222221</c:v>
                </c:pt>
                <c:pt idx="39">
                  <c:v>236.29666666666662</c:v>
                </c:pt>
                <c:pt idx="40">
                  <c:v>236.29888888888885</c:v>
                </c:pt>
                <c:pt idx="41">
                  <c:v>236.29666666666662</c:v>
                </c:pt>
                <c:pt idx="42">
                  <c:v>229.99125000000004</c:v>
                </c:pt>
                <c:pt idx="43">
                  <c:v>229.39400000000001</c:v>
                </c:pt>
                <c:pt idx="44">
                  <c:v>234.97</c:v>
                </c:pt>
              </c:numCache>
            </c:numRef>
          </c:xVal>
          <c:yVal>
            <c:numRef>
              <c:f>Sheet6!$F$250:$F$295</c:f>
              <c:numCache>
                <c:formatCode>General</c:formatCode>
                <c:ptCount val="46"/>
                <c:pt idx="0">
                  <c:v>44.963751136225405</c:v>
                </c:pt>
                <c:pt idx="1">
                  <c:v>30.113358966710841</c:v>
                </c:pt>
                <c:pt idx="2">
                  <c:v>77.053569542833316</c:v>
                </c:pt>
                <c:pt idx="3">
                  <c:v>88.083154176589005</c:v>
                </c:pt>
                <c:pt idx="4">
                  <c:v>45.318614162246526</c:v>
                </c:pt>
                <c:pt idx="5">
                  <c:v>43.643860472409166</c:v>
                </c:pt>
                <c:pt idx="6">
                  <c:v>53.697427402316251</c:v>
                </c:pt>
                <c:pt idx="7">
                  <c:v>55.681632157998912</c:v>
                </c:pt>
                <c:pt idx="8">
                  <c:v>50.327689622665879</c:v>
                </c:pt>
                <c:pt idx="9">
                  <c:v>49.23635646163725</c:v>
                </c:pt>
                <c:pt idx="10">
                  <c:v>62.198138631959075</c:v>
                </c:pt>
                <c:pt idx="11">
                  <c:v>55.580197245461193</c:v>
                </c:pt>
                <c:pt idx="12">
                  <c:v>46.390047649632699</c:v>
                </c:pt>
                <c:pt idx="13">
                  <c:v>44.902768260774238</c:v>
                </c:pt>
                <c:pt idx="14">
                  <c:v>37.24543984182371</c:v>
                </c:pt>
                <c:pt idx="15">
                  <c:v>38.478146384357252</c:v>
                </c:pt>
                <c:pt idx="16">
                  <c:v>32.149466547905291</c:v>
                </c:pt>
                <c:pt idx="17">
                  <c:v>30.448733317410703</c:v>
                </c:pt>
                <c:pt idx="18">
                  <c:v>26.888221912380434</c:v>
                </c:pt>
                <c:pt idx="19">
                  <c:v>29.607844043840799</c:v>
                </c:pt>
                <c:pt idx="20">
                  <c:v>57.990806794435365</c:v>
                </c:pt>
                <c:pt idx="21">
                  <c:v>65.024241016671525</c:v>
                </c:pt>
                <c:pt idx="22">
                  <c:v>75.682596993844484</c:v>
                </c:pt>
                <c:pt idx="23">
                  <c:v>85.195353362912783</c:v>
                </c:pt>
                <c:pt idx="24">
                  <c:v>83.453984648824317</c:v>
                </c:pt>
                <c:pt idx="25">
                  <c:v>88.831425657412282</c:v>
                </c:pt>
                <c:pt idx="26">
                  <c:v>88.676993049998799</c:v>
                </c:pt>
                <c:pt idx="27">
                  <c:v>104.71333888518424</c:v>
                </c:pt>
                <c:pt idx="28">
                  <c:v>94.817451103785132</c:v>
                </c:pt>
                <c:pt idx="29">
                  <c:v>98.604190933590147</c:v>
                </c:pt>
                <c:pt idx="30">
                  <c:v>98.312051143289736</c:v>
                </c:pt>
                <c:pt idx="31">
                  <c:v>85.019987806491756</c:v>
                </c:pt>
                <c:pt idx="32">
                  <c:v>91.64341973325503</c:v>
                </c:pt>
                <c:pt idx="33">
                  <c:v>94.593491295256086</c:v>
                </c:pt>
                <c:pt idx="34">
                  <c:v>97.793122337428017</c:v>
                </c:pt>
                <c:pt idx="35">
                  <c:v>97.392827391491096</c:v>
                </c:pt>
                <c:pt idx="36">
                  <c:v>92.957449809056129</c:v>
                </c:pt>
                <c:pt idx="37">
                  <c:v>84.181181698351679</c:v>
                </c:pt>
                <c:pt idx="38">
                  <c:v>81.147546963487528</c:v>
                </c:pt>
                <c:pt idx="39">
                  <c:v>78.636582385396508</c:v>
                </c:pt>
                <c:pt idx="40">
                  <c:v>75.287290147838775</c:v>
                </c:pt>
                <c:pt idx="41">
                  <c:v>74.322185012712694</c:v>
                </c:pt>
                <c:pt idx="42">
                  <c:v>65.187997441013707</c:v>
                </c:pt>
                <c:pt idx="43">
                  <c:v>69.22767038855973</c:v>
                </c:pt>
                <c:pt idx="44">
                  <c:v>70.41444468087964</c:v>
                </c:pt>
                <c:pt idx="45">
                  <c:v>70.6743149014988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2487808"/>
        <c:axId val="192489344"/>
      </c:scatterChart>
      <c:valAx>
        <c:axId val="192487808"/>
        <c:scaling>
          <c:orientation val="minMax"/>
          <c:max val="400"/>
          <c:min val="-20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solidFill>
                  <a:schemeClr val="tx1"/>
                </a:solidFill>
              </a:defRPr>
            </a:pPr>
            <a:endParaRPr lang="en-US"/>
          </a:p>
        </c:txPr>
        <c:crossAx val="192489344"/>
        <c:crosses val="autoZero"/>
        <c:crossBetween val="midCat"/>
        <c:majorUnit val="200"/>
      </c:valAx>
      <c:valAx>
        <c:axId val="192489344"/>
        <c:scaling>
          <c:orientation val="minMax"/>
          <c:max val="200"/>
          <c:min val="-10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solidFill>
                  <a:schemeClr val="tx1"/>
                </a:solidFill>
              </a:defRPr>
            </a:pPr>
            <a:endParaRPr lang="en-US"/>
          </a:p>
        </c:txPr>
        <c:crossAx val="192487808"/>
        <c:crosses val="autoZero"/>
        <c:crossBetween val="midCat"/>
        <c:majorUnit val="100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3"/>
            <c:spPr>
              <a:noFill/>
              <a:ln>
                <a:solidFill>
                  <a:schemeClr val="tx1"/>
                </a:solidFill>
              </a:ln>
            </c:spPr>
          </c:marker>
          <c:trendline>
            <c:spPr>
              <a:ln>
                <a:solidFill>
                  <a:schemeClr val="tx1"/>
                </a:solidFill>
              </a:ln>
            </c:spPr>
            <c:trendlineType val="linear"/>
            <c:dispRSqr val="1"/>
            <c:dispEq val="1"/>
            <c:trendlineLbl>
              <c:layout>
                <c:manualLayout>
                  <c:x val="0.10900579569727836"/>
                  <c:y val="-0.2471019838071048"/>
                </c:manualLayout>
              </c:layout>
              <c:tx>
                <c:rich>
                  <a:bodyPr/>
                  <a:lstStyle/>
                  <a:p>
                    <a:pPr>
                      <a:defRPr sz="1200">
                        <a:solidFill>
                          <a:schemeClr val="tx1"/>
                        </a:solidFill>
                      </a:defRPr>
                    </a:pPr>
                    <a:r>
                      <a:rPr lang="en-US" baseline="0" dirty="0" smtClean="0"/>
                      <a:t>Patient 5</a:t>
                    </a:r>
                  </a:p>
                  <a:p>
                    <a:pPr>
                      <a:defRPr sz="1200">
                        <a:solidFill>
                          <a:schemeClr val="tx1"/>
                        </a:solidFill>
                      </a:defRPr>
                    </a:pPr>
                    <a:r>
                      <a:rPr lang="en-US" baseline="0" dirty="0" smtClean="0"/>
                      <a:t> r </a:t>
                    </a:r>
                    <a:r>
                      <a:rPr lang="en-US" baseline="0" dirty="0"/>
                      <a:t>= </a:t>
                    </a:r>
                    <a:r>
                      <a:rPr lang="en-US" baseline="0" dirty="0" smtClean="0"/>
                      <a:t>0.73</a:t>
                    </a:r>
                    <a:endParaRPr lang="en-US" dirty="0"/>
                  </a:p>
                </c:rich>
              </c:tx>
              <c:numFmt formatCode="General" sourceLinked="0"/>
            </c:trendlineLbl>
          </c:trendline>
          <c:xVal>
            <c:numRef>
              <c:f>Sheet6!$C$276:$C$324</c:f>
              <c:numCache>
                <c:formatCode>General</c:formatCode>
                <c:ptCount val="49"/>
                <c:pt idx="0">
                  <c:v>86.719750000000005</c:v>
                </c:pt>
                <c:pt idx="1">
                  <c:v>86.620499999999979</c:v>
                </c:pt>
                <c:pt idx="2">
                  <c:v>100.01175000000002</c:v>
                </c:pt>
                <c:pt idx="3">
                  <c:v>156.96125000000001</c:v>
                </c:pt>
                <c:pt idx="4">
                  <c:v>166.46925000000002</c:v>
                </c:pt>
                <c:pt idx="5">
                  <c:v>136.70062499999997</c:v>
                </c:pt>
                <c:pt idx="6">
                  <c:v>124.05587499999997</c:v>
                </c:pt>
                <c:pt idx="7">
                  <c:v>108.72300000000001</c:v>
                </c:pt>
                <c:pt idx="8">
                  <c:v>86.570374999999999</c:v>
                </c:pt>
                <c:pt idx="9">
                  <c:v>67.255749999999978</c:v>
                </c:pt>
                <c:pt idx="10">
                  <c:v>53.366375000000012</c:v>
                </c:pt>
                <c:pt idx="11">
                  <c:v>36.290750000000017</c:v>
                </c:pt>
                <c:pt idx="12">
                  <c:v>29.2</c:v>
                </c:pt>
                <c:pt idx="18">
                  <c:v>54.6</c:v>
                </c:pt>
                <c:pt idx="19">
                  <c:v>83.583625000000012</c:v>
                </c:pt>
                <c:pt idx="20">
                  <c:v>95.829625000000007</c:v>
                </c:pt>
                <c:pt idx="21">
                  <c:v>115.09550000000002</c:v>
                </c:pt>
                <c:pt idx="22">
                  <c:v>137.19762500000002</c:v>
                </c:pt>
                <c:pt idx="23">
                  <c:v>160.14725000000001</c:v>
                </c:pt>
                <c:pt idx="24">
                  <c:v>183.54474999999999</c:v>
                </c:pt>
                <c:pt idx="25">
                  <c:v>193.450875</c:v>
                </c:pt>
                <c:pt idx="26">
                  <c:v>194.84562499999998</c:v>
                </c:pt>
                <c:pt idx="27">
                  <c:v>191.06100000000001</c:v>
                </c:pt>
                <c:pt idx="28">
                  <c:v>187.67649999999998</c:v>
                </c:pt>
                <c:pt idx="29">
                  <c:v>185.28762499999999</c:v>
                </c:pt>
                <c:pt idx="30">
                  <c:v>188.17387499999995</c:v>
                </c:pt>
                <c:pt idx="31">
                  <c:v>188.422875</c:v>
                </c:pt>
                <c:pt idx="32">
                  <c:v>186.38187500000001</c:v>
                </c:pt>
                <c:pt idx="33">
                  <c:v>181.70250000000001</c:v>
                </c:pt>
                <c:pt idx="34">
                  <c:v>175.97774999999999</c:v>
                </c:pt>
                <c:pt idx="35">
                  <c:v>173.638375</c:v>
                </c:pt>
                <c:pt idx="36">
                  <c:v>171.94637499999999</c:v>
                </c:pt>
                <c:pt idx="37">
                  <c:v>174.834</c:v>
                </c:pt>
                <c:pt idx="38">
                  <c:v>177.02374999999998</c:v>
                </c:pt>
                <c:pt idx="39">
                  <c:v>166.818625</c:v>
                </c:pt>
                <c:pt idx="40">
                  <c:v>156.61412499999997</c:v>
                </c:pt>
                <c:pt idx="41">
                  <c:v>163.87059470443398</c:v>
                </c:pt>
                <c:pt idx="42">
                  <c:v>157.85775000000001</c:v>
                </c:pt>
                <c:pt idx="43">
                  <c:v>156.01525000000001</c:v>
                </c:pt>
                <c:pt idx="44">
                  <c:v>154.77112500000001</c:v>
                </c:pt>
                <c:pt idx="45">
                  <c:v>151.98350000000002</c:v>
                </c:pt>
                <c:pt idx="46">
                  <c:v>148.92351666666664</c:v>
                </c:pt>
                <c:pt idx="47">
                  <c:v>149.47353333333334</c:v>
                </c:pt>
                <c:pt idx="48">
                  <c:v>140.072</c:v>
                </c:pt>
              </c:numCache>
            </c:numRef>
          </c:xVal>
          <c:yVal>
            <c:numRef>
              <c:f>Sheet6!$B$276:$B$324</c:f>
              <c:numCache>
                <c:formatCode>General</c:formatCode>
                <c:ptCount val="49"/>
                <c:pt idx="0">
                  <c:v>42.35985826539666</c:v>
                </c:pt>
                <c:pt idx="1">
                  <c:v>54.678633791388847</c:v>
                </c:pt>
                <c:pt idx="2">
                  <c:v>28.480568440755203</c:v>
                </c:pt>
                <c:pt idx="3">
                  <c:v>60.270225941236802</c:v>
                </c:pt>
                <c:pt idx="4">
                  <c:v>92.175233743261458</c:v>
                </c:pt>
                <c:pt idx="5">
                  <c:v>91.209584918298063</c:v>
                </c:pt>
                <c:pt idx="6">
                  <c:v>79.092057878865162</c:v>
                </c:pt>
                <c:pt idx="7">
                  <c:v>78.677814895201763</c:v>
                </c:pt>
                <c:pt idx="8">
                  <c:v>78.238531838313548</c:v>
                </c:pt>
                <c:pt idx="9">
                  <c:v>45.01264309427841</c:v>
                </c:pt>
                <c:pt idx="10">
                  <c:v>40.061684644781344</c:v>
                </c:pt>
                <c:pt idx="11">
                  <c:v>32.758883407343909</c:v>
                </c:pt>
                <c:pt idx="12">
                  <c:v>16.159949629369777</c:v>
                </c:pt>
                <c:pt idx="18">
                  <c:v>15.342905806174629</c:v>
                </c:pt>
                <c:pt idx="19">
                  <c:v>34.094116796073457</c:v>
                </c:pt>
                <c:pt idx="20">
                  <c:v>54.148044177604383</c:v>
                </c:pt>
                <c:pt idx="21">
                  <c:v>70.224658216871873</c:v>
                </c:pt>
                <c:pt idx="22">
                  <c:v>86.587569708364057</c:v>
                </c:pt>
                <c:pt idx="23">
                  <c:v>86.601073857749483</c:v>
                </c:pt>
                <c:pt idx="24">
                  <c:v>94.582725433996742</c:v>
                </c:pt>
                <c:pt idx="25">
                  <c:v>83.510927462638136</c:v>
                </c:pt>
                <c:pt idx="26">
                  <c:v>71.82423184588923</c:v>
                </c:pt>
                <c:pt idx="27">
                  <c:v>66.341883935433472</c:v>
                </c:pt>
                <c:pt idx="28">
                  <c:v>67.017283219703131</c:v>
                </c:pt>
                <c:pt idx="29">
                  <c:v>70.196053613150028</c:v>
                </c:pt>
                <c:pt idx="30">
                  <c:v>92.297886506439156</c:v>
                </c:pt>
                <c:pt idx="31">
                  <c:v>111.74981444684741</c:v>
                </c:pt>
                <c:pt idx="32">
                  <c:v>113.10290461490848</c:v>
                </c:pt>
                <c:pt idx="33">
                  <c:v>105.54667037321884</c:v>
                </c:pt>
                <c:pt idx="34">
                  <c:v>113.51419961332071</c:v>
                </c:pt>
                <c:pt idx="35">
                  <c:v>103.97409176591432</c:v>
                </c:pt>
                <c:pt idx="36">
                  <c:v>109.05089433042932</c:v>
                </c:pt>
                <c:pt idx="37">
                  <c:v>89.416448923454539</c:v>
                </c:pt>
                <c:pt idx="38">
                  <c:v>95.683326994589478</c:v>
                </c:pt>
                <c:pt idx="39">
                  <c:v>97.100994733971007</c:v>
                </c:pt>
                <c:pt idx="40">
                  <c:v>87.467021793913361</c:v>
                </c:pt>
                <c:pt idx="41">
                  <c:v>94.030690809271064</c:v>
                </c:pt>
                <c:pt idx="42">
                  <c:v>89.523977881857903</c:v>
                </c:pt>
                <c:pt idx="43">
                  <c:v>78.450402407347312</c:v>
                </c:pt>
                <c:pt idx="44">
                  <c:v>50.901060293954686</c:v>
                </c:pt>
                <c:pt idx="45">
                  <c:v>27.948008943236363</c:v>
                </c:pt>
                <c:pt idx="46">
                  <c:v>32.501960892821003</c:v>
                </c:pt>
                <c:pt idx="47">
                  <c:v>57.059138503431129</c:v>
                </c:pt>
                <c:pt idx="48">
                  <c:v>65.38367684975754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2534400"/>
        <c:axId val="192535936"/>
      </c:scatterChart>
      <c:valAx>
        <c:axId val="192534400"/>
        <c:scaling>
          <c:orientation val="minMax"/>
          <c:max val="400"/>
          <c:min val="-20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solidFill>
                  <a:schemeClr val="tx1"/>
                </a:solidFill>
              </a:defRPr>
            </a:pPr>
            <a:endParaRPr lang="en-US"/>
          </a:p>
        </c:txPr>
        <c:crossAx val="192535936"/>
        <c:crosses val="autoZero"/>
        <c:crossBetween val="midCat"/>
        <c:majorUnit val="200"/>
      </c:valAx>
      <c:valAx>
        <c:axId val="192535936"/>
        <c:scaling>
          <c:orientation val="minMax"/>
          <c:max val="200"/>
          <c:min val="-10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solidFill>
                  <a:schemeClr val="tx1"/>
                </a:solidFill>
              </a:defRPr>
            </a:pPr>
            <a:endParaRPr lang="en-US"/>
          </a:p>
        </c:txPr>
        <c:crossAx val="192534400"/>
        <c:crosses val="autoZero"/>
        <c:crossBetween val="midCat"/>
        <c:majorUnit val="100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3"/>
            <c:spPr>
              <a:noFill/>
              <a:ln>
                <a:solidFill>
                  <a:schemeClr val="tx1"/>
                </a:solidFill>
              </a:ln>
            </c:spPr>
          </c:marker>
          <c:trendline>
            <c:spPr>
              <a:ln>
                <a:solidFill>
                  <a:schemeClr val="tx1"/>
                </a:solidFill>
              </a:ln>
            </c:spPr>
            <c:trendlineType val="linear"/>
            <c:dispRSqr val="1"/>
            <c:dispEq val="1"/>
            <c:trendlineLbl>
              <c:layout>
                <c:manualLayout>
                  <c:x val="-9.1103793618432807E-2"/>
                  <c:y val="-0.16487783861643673"/>
                </c:manualLayout>
              </c:layout>
              <c:tx>
                <c:rich>
                  <a:bodyPr/>
                  <a:lstStyle/>
                  <a:p>
                    <a:pPr>
                      <a:defRPr sz="1200">
                        <a:solidFill>
                          <a:schemeClr val="tx1"/>
                        </a:solidFill>
                      </a:defRPr>
                    </a:pPr>
                    <a:r>
                      <a:rPr lang="en-US" baseline="0" dirty="0" smtClean="0"/>
                      <a:t>Patient 2 </a:t>
                    </a:r>
                  </a:p>
                  <a:p>
                    <a:pPr>
                      <a:defRPr sz="1200">
                        <a:solidFill>
                          <a:schemeClr val="tx1"/>
                        </a:solidFill>
                      </a:defRPr>
                    </a:pPr>
                    <a:r>
                      <a:rPr lang="en-US" baseline="0" dirty="0" smtClean="0"/>
                      <a:t>r </a:t>
                    </a:r>
                    <a:r>
                      <a:rPr lang="en-US" baseline="0" dirty="0"/>
                      <a:t>= </a:t>
                    </a:r>
                    <a:r>
                      <a:rPr lang="en-US" baseline="0" dirty="0" smtClean="0"/>
                      <a:t>0.89</a:t>
                    </a:r>
                    <a:endParaRPr lang="en-US" dirty="0"/>
                  </a:p>
                </c:rich>
              </c:tx>
              <c:numFmt formatCode="General" sourceLinked="0"/>
            </c:trendlineLbl>
          </c:trendline>
          <c:xVal>
            <c:numRef>
              <c:f>Sheet6!$Q$264:$Q$312</c:f>
              <c:numCache>
                <c:formatCode>General</c:formatCode>
                <c:ptCount val="49"/>
                <c:pt idx="0">
                  <c:v>176.22250000000003</c:v>
                </c:pt>
                <c:pt idx="1">
                  <c:v>189.10437499999998</c:v>
                </c:pt>
                <c:pt idx="2">
                  <c:v>215.98625000000001</c:v>
                </c:pt>
                <c:pt idx="3">
                  <c:v>212.06687499999998</c:v>
                </c:pt>
                <c:pt idx="4">
                  <c:v>166.14312499999997</c:v>
                </c:pt>
                <c:pt idx="5">
                  <c:v>148.59437499999999</c:v>
                </c:pt>
                <c:pt idx="6">
                  <c:v>145.98250000000004</c:v>
                </c:pt>
                <c:pt idx="7">
                  <c:v>139.44749999999999</c:v>
                </c:pt>
                <c:pt idx="8">
                  <c:v>123.02</c:v>
                </c:pt>
                <c:pt idx="10">
                  <c:v>90.539374999999993</c:v>
                </c:pt>
                <c:pt idx="11">
                  <c:v>83.817500000000024</c:v>
                </c:pt>
                <c:pt idx="12">
                  <c:v>86.245625000000047</c:v>
                </c:pt>
                <c:pt idx="13">
                  <c:v>86.618749999999991</c:v>
                </c:pt>
                <c:pt idx="14">
                  <c:v>86.432500000000033</c:v>
                </c:pt>
                <c:pt idx="15">
                  <c:v>85.685000000000002</c:v>
                </c:pt>
                <c:pt idx="16">
                  <c:v>87.177500000000009</c:v>
                </c:pt>
                <c:pt idx="17">
                  <c:v>82.698125000000005</c:v>
                </c:pt>
                <c:pt idx="18">
                  <c:v>102.48687500000001</c:v>
                </c:pt>
                <c:pt idx="19">
                  <c:v>161.47687499999998</c:v>
                </c:pt>
                <c:pt idx="21">
                  <c:v>219.15937499999995</c:v>
                </c:pt>
                <c:pt idx="22">
                  <c:v>246.60062500000001</c:v>
                </c:pt>
                <c:pt idx="23">
                  <c:v>285.43062499999991</c:v>
                </c:pt>
                <c:pt idx="24">
                  <c:v>320.33874999999995</c:v>
                </c:pt>
                <c:pt idx="25">
                  <c:v>337.88750000000005</c:v>
                </c:pt>
                <c:pt idx="26">
                  <c:v>348.3406250000001</c:v>
                </c:pt>
                <c:pt idx="27">
                  <c:v>348.34000000000009</c:v>
                </c:pt>
                <c:pt idx="28">
                  <c:v>353.56687499999992</c:v>
                </c:pt>
                <c:pt idx="29">
                  <c:v>351.13937500000009</c:v>
                </c:pt>
                <c:pt idx="30">
                  <c:v>342.92624999999987</c:v>
                </c:pt>
                <c:pt idx="31">
                  <c:v>332.65937500000001</c:v>
                </c:pt>
                <c:pt idx="32">
                  <c:v>322.7662499999999</c:v>
                </c:pt>
                <c:pt idx="33">
                  <c:v>319.21812499999993</c:v>
                </c:pt>
                <c:pt idx="34">
                  <c:v>314.36562500000002</c:v>
                </c:pt>
                <c:pt idx="35">
                  <c:v>313.43187499999993</c:v>
                </c:pt>
                <c:pt idx="36">
                  <c:v>310.25750000000005</c:v>
                </c:pt>
                <c:pt idx="37">
                  <c:v>299.80312499999991</c:v>
                </c:pt>
                <c:pt idx="38">
                  <c:v>293.64375000000001</c:v>
                </c:pt>
                <c:pt idx="39">
                  <c:v>286.36374999999992</c:v>
                </c:pt>
                <c:pt idx="40">
                  <c:v>278.52187499999997</c:v>
                </c:pt>
                <c:pt idx="41">
                  <c:v>265.8287499999999</c:v>
                </c:pt>
                <c:pt idx="42">
                  <c:v>249.89800000000002</c:v>
                </c:pt>
                <c:pt idx="43">
                  <c:v>238.25769230769234</c:v>
                </c:pt>
                <c:pt idx="44">
                  <c:v>223.26666666666665</c:v>
                </c:pt>
                <c:pt idx="45">
                  <c:v>209.07899999999998</c:v>
                </c:pt>
                <c:pt idx="46">
                  <c:v>192.27874999999997</c:v>
                </c:pt>
                <c:pt idx="47">
                  <c:v>191.905</c:v>
                </c:pt>
                <c:pt idx="48">
                  <c:v>182.19666666666663</c:v>
                </c:pt>
              </c:numCache>
            </c:numRef>
          </c:xVal>
          <c:yVal>
            <c:numRef>
              <c:f>Sheet6!$P$264:$P$312</c:f>
              <c:numCache>
                <c:formatCode>General</c:formatCode>
                <c:ptCount val="49"/>
                <c:pt idx="1">
                  <c:v>64.825700806395659</c:v>
                </c:pt>
                <c:pt idx="2">
                  <c:v>84.714600219783776</c:v>
                </c:pt>
                <c:pt idx="3">
                  <c:v>71.332625716726326</c:v>
                </c:pt>
                <c:pt idx="4">
                  <c:v>49.00527049582945</c:v>
                </c:pt>
                <c:pt idx="5">
                  <c:v>47.367446430164115</c:v>
                </c:pt>
                <c:pt idx="6">
                  <c:v>53.82589207606631</c:v>
                </c:pt>
                <c:pt idx="7">
                  <c:v>44.431257905397096</c:v>
                </c:pt>
                <c:pt idx="8">
                  <c:v>25.593670702171288</c:v>
                </c:pt>
                <c:pt idx="10">
                  <c:v>18.926042276711065</c:v>
                </c:pt>
                <c:pt idx="11">
                  <c:v>26.139447748829639</c:v>
                </c:pt>
                <c:pt idx="12">
                  <c:v>26.303404147583812</c:v>
                </c:pt>
                <c:pt idx="13">
                  <c:v>24.542502618503885</c:v>
                </c:pt>
                <c:pt idx="14">
                  <c:v>23.977932022726208</c:v>
                </c:pt>
                <c:pt idx="15">
                  <c:v>26.312592397294605</c:v>
                </c:pt>
                <c:pt idx="16">
                  <c:v>28.43763450317859</c:v>
                </c:pt>
                <c:pt idx="17">
                  <c:v>29.006803046654408</c:v>
                </c:pt>
                <c:pt idx="18">
                  <c:v>33.622246251704205</c:v>
                </c:pt>
                <c:pt idx="19">
                  <c:v>24.578847545971168</c:v>
                </c:pt>
                <c:pt idx="21">
                  <c:v>15.772589002228207</c:v>
                </c:pt>
                <c:pt idx="22">
                  <c:v>50.026625963490758</c:v>
                </c:pt>
                <c:pt idx="23">
                  <c:v>69.456560271504003</c:v>
                </c:pt>
                <c:pt idx="24">
                  <c:v>75.461113130299992</c:v>
                </c:pt>
                <c:pt idx="25">
                  <c:v>82.675286456620142</c:v>
                </c:pt>
                <c:pt idx="26">
                  <c:v>96.725566089380465</c:v>
                </c:pt>
                <c:pt idx="27">
                  <c:v>109.46597530590017</c:v>
                </c:pt>
                <c:pt idx="28">
                  <c:v>115.4518484187773</c:v>
                </c:pt>
                <c:pt idx="29">
                  <c:v>118.10041551507771</c:v>
                </c:pt>
                <c:pt idx="30">
                  <c:v>115.43155220851052</c:v>
                </c:pt>
                <c:pt idx="31">
                  <c:v>109.75492064072166</c:v>
                </c:pt>
                <c:pt idx="32">
                  <c:v>107.92137063602144</c:v>
                </c:pt>
                <c:pt idx="33">
                  <c:v>109.91985780332783</c:v>
                </c:pt>
                <c:pt idx="34">
                  <c:v>117.17822834532417</c:v>
                </c:pt>
                <c:pt idx="35">
                  <c:v>119.38425608030253</c:v>
                </c:pt>
                <c:pt idx="36">
                  <c:v>115.40519382758814</c:v>
                </c:pt>
                <c:pt idx="37">
                  <c:v>117.21611919566382</c:v>
                </c:pt>
                <c:pt idx="38">
                  <c:v>107.82068813290513</c:v>
                </c:pt>
                <c:pt idx="39">
                  <c:v>104.39148648288351</c:v>
                </c:pt>
                <c:pt idx="40">
                  <c:v>93.499840113699989</c:v>
                </c:pt>
                <c:pt idx="41">
                  <c:v>87.984076452187409</c:v>
                </c:pt>
                <c:pt idx="42">
                  <c:v>84.789908819440399</c:v>
                </c:pt>
                <c:pt idx="43">
                  <c:v>80.512415373476827</c:v>
                </c:pt>
                <c:pt idx="44">
                  <c:v>76.490986680228588</c:v>
                </c:pt>
                <c:pt idx="45">
                  <c:v>81.974896757264858</c:v>
                </c:pt>
                <c:pt idx="46">
                  <c:v>83.430342055012247</c:v>
                </c:pt>
                <c:pt idx="47">
                  <c:v>88.054527795716595</c:v>
                </c:pt>
                <c:pt idx="48">
                  <c:v>87.59860208347610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2585088"/>
        <c:axId val="192590976"/>
      </c:scatterChart>
      <c:valAx>
        <c:axId val="192585088"/>
        <c:scaling>
          <c:orientation val="minMax"/>
          <c:max val="400"/>
          <c:min val="-20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solidFill>
                  <a:schemeClr val="tx1"/>
                </a:solidFill>
              </a:defRPr>
            </a:pPr>
            <a:endParaRPr lang="en-US"/>
          </a:p>
        </c:txPr>
        <c:crossAx val="192590976"/>
        <c:crosses val="autoZero"/>
        <c:crossBetween val="midCat"/>
        <c:majorUnit val="200"/>
      </c:valAx>
      <c:valAx>
        <c:axId val="192590976"/>
        <c:scaling>
          <c:orientation val="minMax"/>
          <c:max val="200"/>
          <c:min val="-10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solidFill>
                  <a:schemeClr val="tx1"/>
                </a:solidFill>
              </a:defRPr>
            </a:pPr>
            <a:endParaRPr lang="en-US"/>
          </a:p>
        </c:txPr>
        <c:crossAx val="192585088"/>
        <c:crosses val="autoZero"/>
        <c:crossBetween val="midCat"/>
        <c:majorUnit val="100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6!$G$243:$G$244</c:f>
              <c:strCache>
                <c:ptCount val="1"/>
                <c:pt idx="0">
                  <c:v>170.0553333 150.94</c:v>
                </c:pt>
              </c:strCache>
            </c:strRef>
          </c:tx>
          <c:spPr>
            <a:ln w="28575">
              <a:noFill/>
            </a:ln>
          </c:spPr>
          <c:marker>
            <c:symbol val="circle"/>
            <c:size val="3"/>
            <c:spPr>
              <a:noFill/>
              <a:ln>
                <a:solidFill>
                  <a:schemeClr val="tx1"/>
                </a:solidFill>
              </a:ln>
            </c:spPr>
          </c:marker>
          <c:trendline>
            <c:spPr>
              <a:ln>
                <a:solidFill>
                  <a:schemeClr val="tx1"/>
                </a:solidFill>
              </a:ln>
            </c:spPr>
            <c:trendlineType val="linear"/>
            <c:dispRSqr val="1"/>
            <c:dispEq val="1"/>
            <c:trendlineLbl>
              <c:layout>
                <c:manualLayout>
                  <c:x val="9.3226853767866269E-2"/>
                  <c:y val="-0.38308510032587911"/>
                </c:manualLayout>
              </c:layout>
              <c:tx>
                <c:rich>
                  <a:bodyPr/>
                  <a:lstStyle/>
                  <a:p>
                    <a:pPr>
                      <a:defRPr sz="1200">
                        <a:solidFill>
                          <a:schemeClr val="tx1"/>
                        </a:solidFill>
                      </a:defRPr>
                    </a:pPr>
                    <a:r>
                      <a:rPr lang="en-US" baseline="0" dirty="0" smtClean="0"/>
                      <a:t>Patient 6 </a:t>
                    </a:r>
                  </a:p>
                  <a:p>
                    <a:pPr>
                      <a:defRPr sz="1200">
                        <a:solidFill>
                          <a:schemeClr val="tx1"/>
                        </a:solidFill>
                      </a:defRPr>
                    </a:pPr>
                    <a:r>
                      <a:rPr lang="en-US" baseline="0" dirty="0" smtClean="0"/>
                      <a:t>r </a:t>
                    </a:r>
                    <a:r>
                      <a:rPr lang="en-US" baseline="0" dirty="0"/>
                      <a:t>= </a:t>
                    </a:r>
                    <a:r>
                      <a:rPr lang="en-US" baseline="0" dirty="0" smtClean="0"/>
                      <a:t>0.82</a:t>
                    </a:r>
                    <a:endParaRPr lang="en-US" dirty="0"/>
                  </a:p>
                </c:rich>
              </c:tx>
              <c:numFmt formatCode="General" sourceLinked="0"/>
            </c:trendlineLbl>
          </c:trendline>
          <c:xVal>
            <c:numRef>
              <c:f>Sheet6!$G$245:$G$292</c:f>
              <c:numCache>
                <c:formatCode>General</c:formatCode>
                <c:ptCount val="48"/>
                <c:pt idx="0">
                  <c:v>70.092666666666673</c:v>
                </c:pt>
                <c:pt idx="1">
                  <c:v>51.771999999999998</c:v>
                </c:pt>
                <c:pt idx="2">
                  <c:v>123.85599999999998</c:v>
                </c:pt>
                <c:pt idx="3">
                  <c:v>171.24933333333331</c:v>
                </c:pt>
                <c:pt idx="4">
                  <c:v>153.72600000000003</c:v>
                </c:pt>
                <c:pt idx="5">
                  <c:v>142.97266666666664</c:v>
                </c:pt>
                <c:pt idx="6">
                  <c:v>137.39666666666665</c:v>
                </c:pt>
                <c:pt idx="7">
                  <c:v>136.99800000000002</c:v>
                </c:pt>
                <c:pt idx="8">
                  <c:v>148.54933333333335</c:v>
                </c:pt>
                <c:pt idx="9">
                  <c:v>157.31133333333341</c:v>
                </c:pt>
                <c:pt idx="10">
                  <c:v>156.91400000000002</c:v>
                </c:pt>
                <c:pt idx="11">
                  <c:v>159.30200000000005</c:v>
                </c:pt>
                <c:pt idx="12">
                  <c:v>163.28466666666668</c:v>
                </c:pt>
                <c:pt idx="13">
                  <c:v>166.47133333333338</c:v>
                </c:pt>
                <c:pt idx="14">
                  <c:v>168.46133333333341</c:v>
                </c:pt>
                <c:pt idx="15">
                  <c:v>167.26733333333337</c:v>
                </c:pt>
                <c:pt idx="16">
                  <c:v>166.47066666666663</c:v>
                </c:pt>
                <c:pt idx="17">
                  <c:v>167.666</c:v>
                </c:pt>
                <c:pt idx="18">
                  <c:v>199.12733333333341</c:v>
                </c:pt>
                <c:pt idx="19">
                  <c:v>301.08066666666679</c:v>
                </c:pt>
                <c:pt idx="20">
                  <c:v>321.79066666666677</c:v>
                </c:pt>
                <c:pt idx="21">
                  <c:v>341.30400000000009</c:v>
                </c:pt>
                <c:pt idx="22">
                  <c:v>353.65000000000009</c:v>
                </c:pt>
                <c:pt idx="23">
                  <c:v>371.1733333333334</c:v>
                </c:pt>
                <c:pt idx="24">
                  <c:v>362.01333333333332</c:v>
                </c:pt>
                <c:pt idx="25">
                  <c:v>349.66800000000006</c:v>
                </c:pt>
                <c:pt idx="26">
                  <c:v>346.48200000000003</c:v>
                </c:pt>
                <c:pt idx="27">
                  <c:v>340.50666666666672</c:v>
                </c:pt>
                <c:pt idx="28">
                  <c:v>342.49866666666674</c:v>
                </c:pt>
                <c:pt idx="29">
                  <c:v>329.75400000000002</c:v>
                </c:pt>
                <c:pt idx="30">
                  <c:v>300.28399999999988</c:v>
                </c:pt>
                <c:pt idx="31">
                  <c:v>283.55733333333336</c:v>
                </c:pt>
                <c:pt idx="32">
                  <c:v>263.24733333333342</c:v>
                </c:pt>
                <c:pt idx="33">
                  <c:v>253.28933333333336</c:v>
                </c:pt>
                <c:pt idx="34">
                  <c:v>246.51933333333335</c:v>
                </c:pt>
                <c:pt idx="35">
                  <c:v>242.53733333333338</c:v>
                </c:pt>
                <c:pt idx="36">
                  <c:v>242.13733333333332</c:v>
                </c:pt>
                <c:pt idx="37">
                  <c:v>243.73199999999997</c:v>
                </c:pt>
                <c:pt idx="38">
                  <c:v>245.32533333333342</c:v>
                </c:pt>
                <c:pt idx="39">
                  <c:v>233.77600000000001</c:v>
                </c:pt>
                <c:pt idx="40">
                  <c:v>234.57333333333338</c:v>
                </c:pt>
                <c:pt idx="41">
                  <c:v>244.13133333333337</c:v>
                </c:pt>
                <c:pt idx="42">
                  <c:v>234.97133333333343</c:v>
                </c:pt>
                <c:pt idx="43">
                  <c:v>211.64285714285711</c:v>
                </c:pt>
                <c:pt idx="44">
                  <c:v>180.92000000000002</c:v>
                </c:pt>
                <c:pt idx="45">
                  <c:v>164.00909090909093</c:v>
                </c:pt>
              </c:numCache>
            </c:numRef>
          </c:xVal>
          <c:yVal>
            <c:numRef>
              <c:f>Sheet6!$F$245:$F$292</c:f>
              <c:numCache>
                <c:formatCode>General</c:formatCode>
                <c:ptCount val="48"/>
                <c:pt idx="2">
                  <c:v>68.925197657259119</c:v>
                </c:pt>
                <c:pt idx="3">
                  <c:v>99.81762543199963</c:v>
                </c:pt>
                <c:pt idx="4">
                  <c:v>87.387932504404404</c:v>
                </c:pt>
                <c:pt idx="5">
                  <c:v>50.755852249787978</c:v>
                </c:pt>
                <c:pt idx="6">
                  <c:v>56.070273273242194</c:v>
                </c:pt>
                <c:pt idx="7">
                  <c:v>54.948259143574205</c:v>
                </c:pt>
                <c:pt idx="8">
                  <c:v>54.008514640867254</c:v>
                </c:pt>
                <c:pt idx="9">
                  <c:v>45.718016517833156</c:v>
                </c:pt>
                <c:pt idx="10">
                  <c:v>45.924878049953819</c:v>
                </c:pt>
                <c:pt idx="11">
                  <c:v>32.580222405095746</c:v>
                </c:pt>
                <c:pt idx="12">
                  <c:v>30.292067556037679</c:v>
                </c:pt>
                <c:pt idx="13">
                  <c:v>43.861202990067227</c:v>
                </c:pt>
                <c:pt idx="14">
                  <c:v>46.440544533287792</c:v>
                </c:pt>
                <c:pt idx="15">
                  <c:v>38.494243261560634</c:v>
                </c:pt>
                <c:pt idx="16">
                  <c:v>29.897057405296678</c:v>
                </c:pt>
                <c:pt idx="17">
                  <c:v>52.378135595936861</c:v>
                </c:pt>
                <c:pt idx="18">
                  <c:v>93.185059136737195</c:v>
                </c:pt>
                <c:pt idx="19">
                  <c:v>98.84818941553111</c:v>
                </c:pt>
                <c:pt idx="20">
                  <c:v>93.228648008315616</c:v>
                </c:pt>
                <c:pt idx="21">
                  <c:v>113.11741117788748</c:v>
                </c:pt>
                <c:pt idx="22">
                  <c:v>121.78813993614435</c:v>
                </c:pt>
                <c:pt idx="23">
                  <c:v>119.35328791625595</c:v>
                </c:pt>
                <c:pt idx="24">
                  <c:v>121.40735611605002</c:v>
                </c:pt>
                <c:pt idx="25">
                  <c:v>101.45701322380604</c:v>
                </c:pt>
                <c:pt idx="26">
                  <c:v>128.50491234782535</c:v>
                </c:pt>
                <c:pt idx="27">
                  <c:v>146.16777919388957</c:v>
                </c:pt>
                <c:pt idx="28">
                  <c:v>141.41452055453058</c:v>
                </c:pt>
                <c:pt idx="29">
                  <c:v>120.69486506544062</c:v>
                </c:pt>
                <c:pt idx="30">
                  <c:v>111.27581312134208</c:v>
                </c:pt>
                <c:pt idx="31">
                  <c:v>115.40536331774682</c:v>
                </c:pt>
                <c:pt idx="32">
                  <c:v>125.85296104571945</c:v>
                </c:pt>
                <c:pt idx="33">
                  <c:v>125.24807969490833</c:v>
                </c:pt>
                <c:pt idx="34">
                  <c:v>108.55565915994109</c:v>
                </c:pt>
                <c:pt idx="35">
                  <c:v>120.50421162481356</c:v>
                </c:pt>
                <c:pt idx="36">
                  <c:v>122.10353544751968</c:v>
                </c:pt>
                <c:pt idx="37">
                  <c:v>113.30129130905223</c:v>
                </c:pt>
                <c:pt idx="38">
                  <c:v>100.15830821686878</c:v>
                </c:pt>
                <c:pt idx="39">
                  <c:v>84.233082522985598</c:v>
                </c:pt>
                <c:pt idx="40">
                  <c:v>90.067095033649082</c:v>
                </c:pt>
                <c:pt idx="41">
                  <c:v>99.735259965274608</c:v>
                </c:pt>
                <c:pt idx="42">
                  <c:v>93.746253465288021</c:v>
                </c:pt>
                <c:pt idx="43">
                  <c:v>90.914517147974905</c:v>
                </c:pt>
                <c:pt idx="44">
                  <c:v>81.270778010827144</c:v>
                </c:pt>
                <c:pt idx="45">
                  <c:v>61.386305183034516</c:v>
                </c:pt>
                <c:pt idx="46">
                  <c:v>49.685326335748691</c:v>
                </c:pt>
                <c:pt idx="47">
                  <c:v>36.18469343116625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2819072"/>
        <c:axId val="202820608"/>
      </c:scatterChart>
      <c:valAx>
        <c:axId val="202819072"/>
        <c:scaling>
          <c:orientation val="minMax"/>
          <c:max val="800"/>
          <c:min val="-20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solidFill>
                  <a:schemeClr val="tx1"/>
                </a:solidFill>
              </a:defRPr>
            </a:pPr>
            <a:endParaRPr lang="en-US"/>
          </a:p>
        </c:txPr>
        <c:crossAx val="202820608"/>
        <c:crosses val="autoZero"/>
        <c:crossBetween val="midCat"/>
        <c:majorUnit val="200"/>
      </c:valAx>
      <c:valAx>
        <c:axId val="202820608"/>
        <c:scaling>
          <c:orientation val="minMax"/>
          <c:max val="400"/>
          <c:min val="-10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solidFill>
                  <a:schemeClr val="tx1"/>
                </a:solidFill>
              </a:defRPr>
            </a:pPr>
            <a:endParaRPr lang="en-US"/>
          </a:p>
        </c:txPr>
        <c:crossAx val="202819072"/>
        <c:crosses val="autoZero"/>
        <c:crossBetween val="midCat"/>
        <c:majorUnit val="100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3"/>
            <c:spPr>
              <a:noFill/>
              <a:ln>
                <a:solidFill>
                  <a:schemeClr val="tx1"/>
                </a:solidFill>
              </a:ln>
            </c:spPr>
          </c:marker>
          <c:trendline>
            <c:trendlineType val="linear"/>
            <c:dispRSqr val="1"/>
            <c:dispEq val="1"/>
            <c:trendlineLbl>
              <c:layout>
                <c:manualLayout>
                  <c:x val="-0.11799765138617921"/>
                  <c:y val="-0.35189909771916811"/>
                </c:manualLayout>
              </c:layout>
              <c:tx>
                <c:rich>
                  <a:bodyPr/>
                  <a:lstStyle/>
                  <a:p>
                    <a:pPr>
                      <a:defRPr sz="1200">
                        <a:solidFill>
                          <a:schemeClr val="tx1"/>
                        </a:solidFill>
                      </a:defRPr>
                    </a:pPr>
                    <a:r>
                      <a:rPr lang="en-US" baseline="0" dirty="0" smtClean="0"/>
                      <a:t>Patient 8</a:t>
                    </a:r>
                  </a:p>
                  <a:p>
                    <a:pPr>
                      <a:defRPr sz="1200">
                        <a:solidFill>
                          <a:schemeClr val="tx1"/>
                        </a:solidFill>
                      </a:defRPr>
                    </a:pPr>
                    <a:r>
                      <a:rPr lang="en-US" baseline="0" dirty="0" smtClean="0"/>
                      <a:t>r </a:t>
                    </a:r>
                    <a:r>
                      <a:rPr lang="en-US" baseline="0" dirty="0"/>
                      <a:t>= </a:t>
                    </a:r>
                    <a:r>
                      <a:rPr lang="en-US" baseline="0" dirty="0" smtClean="0"/>
                      <a:t>0.77</a:t>
                    </a:r>
                    <a:endParaRPr lang="en-US" dirty="0"/>
                  </a:p>
                </c:rich>
              </c:tx>
              <c:numFmt formatCode="General" sourceLinked="0"/>
            </c:trendlineLbl>
          </c:trendline>
          <c:xVal>
            <c:numRef>
              <c:f>Sheet6!$C$303:$C$352</c:f>
              <c:numCache>
                <c:formatCode>General</c:formatCode>
                <c:ptCount val="50"/>
                <c:pt idx="0">
                  <c:v>296.84071428571428</c:v>
                </c:pt>
                <c:pt idx="1">
                  <c:v>329.26928571428573</c:v>
                </c:pt>
                <c:pt idx="2">
                  <c:v>346.48071428571427</c:v>
                </c:pt>
                <c:pt idx="3">
                  <c:v>242.50785714285715</c:v>
                </c:pt>
                <c:pt idx="4">
                  <c:v>259.7178571428571</c:v>
                </c:pt>
                <c:pt idx="5">
                  <c:v>307.22357142857135</c:v>
                </c:pt>
                <c:pt idx="6">
                  <c:v>312.05928571428575</c:v>
                </c:pt>
                <c:pt idx="7">
                  <c:v>343.49285714285713</c:v>
                </c:pt>
                <c:pt idx="8">
                  <c:v>329.83857142857136</c:v>
                </c:pt>
                <c:pt idx="9">
                  <c:v>338.65571428571434</c:v>
                </c:pt>
                <c:pt idx="10">
                  <c:v>353.73357142857139</c:v>
                </c:pt>
                <c:pt idx="11">
                  <c:v>360.13357142857143</c:v>
                </c:pt>
                <c:pt idx="12">
                  <c:v>374.92642857142863</c:v>
                </c:pt>
                <c:pt idx="13">
                  <c:v>377.06071428571425</c:v>
                </c:pt>
                <c:pt idx="14">
                  <c:v>373.07714285714275</c:v>
                </c:pt>
                <c:pt idx="15">
                  <c:v>357.005</c:v>
                </c:pt>
                <c:pt idx="16">
                  <c:v>340.50571428571425</c:v>
                </c:pt>
                <c:pt idx="17">
                  <c:v>324.00714285714281</c:v>
                </c:pt>
                <c:pt idx="18">
                  <c:v>317.17785714285725</c:v>
                </c:pt>
                <c:pt idx="19">
                  <c:v>263.27285714285716</c:v>
                </c:pt>
                <c:pt idx="20">
                  <c:v>219.32428571428571</c:v>
                </c:pt>
                <c:pt idx="21">
                  <c:v>397.96999999999997</c:v>
                </c:pt>
                <c:pt idx="22">
                  <c:v>578.46642857142842</c:v>
                </c:pt>
                <c:pt idx="23">
                  <c:v>622.55785714285719</c:v>
                </c:pt>
                <c:pt idx="24">
                  <c:v>630.38071428571413</c:v>
                </c:pt>
                <c:pt idx="25">
                  <c:v>623.83857142857153</c:v>
                </c:pt>
                <c:pt idx="26">
                  <c:v>639.62785714285712</c:v>
                </c:pt>
                <c:pt idx="27">
                  <c:v>632.94142857142845</c:v>
                </c:pt>
                <c:pt idx="28">
                  <c:v>610.4671428571429</c:v>
                </c:pt>
                <c:pt idx="29">
                  <c:v>585.0085714285716</c:v>
                </c:pt>
                <c:pt idx="30">
                  <c:v>547.60071428571439</c:v>
                </c:pt>
                <c:pt idx="31">
                  <c:v>535.93857142857155</c:v>
                </c:pt>
                <c:pt idx="32">
                  <c:v>527.68785714285718</c:v>
                </c:pt>
                <c:pt idx="33">
                  <c:v>500.80571428571426</c:v>
                </c:pt>
                <c:pt idx="34">
                  <c:v>478.90214285714291</c:v>
                </c:pt>
                <c:pt idx="35">
                  <c:v>472.92785714285719</c:v>
                </c:pt>
                <c:pt idx="36">
                  <c:v>471.50571428571425</c:v>
                </c:pt>
                <c:pt idx="37">
                  <c:v>461.12142857142862</c:v>
                </c:pt>
                <c:pt idx="38">
                  <c:v>448.32</c:v>
                </c:pt>
                <c:pt idx="39">
                  <c:v>444.19428571428568</c:v>
                </c:pt>
                <c:pt idx="40">
                  <c:v>432.95785714285716</c:v>
                </c:pt>
                <c:pt idx="41">
                  <c:v>430.11285714285719</c:v>
                </c:pt>
                <c:pt idx="42">
                  <c:v>443.05642857142851</c:v>
                </c:pt>
                <c:pt idx="43">
                  <c:v>429.97214285714273</c:v>
                </c:pt>
                <c:pt idx="44">
                  <c:v>390.57214285714275</c:v>
                </c:pt>
                <c:pt idx="45">
                  <c:v>346.02000000000004</c:v>
                </c:pt>
                <c:pt idx="46">
                  <c:v>299.08700000000005</c:v>
                </c:pt>
                <c:pt idx="47">
                  <c:v>270.81</c:v>
                </c:pt>
              </c:numCache>
            </c:numRef>
          </c:xVal>
          <c:yVal>
            <c:numRef>
              <c:f>Sheet6!$B$303:$B$352</c:f>
              <c:numCache>
                <c:formatCode>General</c:formatCode>
                <c:ptCount val="50"/>
                <c:pt idx="0">
                  <c:v>82.843573086700403</c:v>
                </c:pt>
                <c:pt idx="1">
                  <c:v>58.338901486384501</c:v>
                </c:pt>
                <c:pt idx="2">
                  <c:v>32.306864667675953</c:v>
                </c:pt>
                <c:pt idx="3">
                  <c:v>50.952446686324208</c:v>
                </c:pt>
                <c:pt idx="4">
                  <c:v>73.398680395262573</c:v>
                </c:pt>
                <c:pt idx="5">
                  <c:v>49.388360597628541</c:v>
                </c:pt>
                <c:pt idx="6">
                  <c:v>48.162368670181188</c:v>
                </c:pt>
                <c:pt idx="7">
                  <c:v>86.84225566382743</c:v>
                </c:pt>
                <c:pt idx="8">
                  <c:v>93.760678978655761</c:v>
                </c:pt>
                <c:pt idx="9">
                  <c:v>94.072494187245212</c:v>
                </c:pt>
                <c:pt idx="10">
                  <c:v>111.27027406378761</c:v>
                </c:pt>
                <c:pt idx="11">
                  <c:v>114.53207733298748</c:v>
                </c:pt>
                <c:pt idx="12">
                  <c:v>82.646244653483748</c:v>
                </c:pt>
                <c:pt idx="13">
                  <c:v>91.965570005392237</c:v>
                </c:pt>
                <c:pt idx="14">
                  <c:v>83.811182398118262</c:v>
                </c:pt>
                <c:pt idx="15">
                  <c:v>69.057946411289322</c:v>
                </c:pt>
                <c:pt idx="16">
                  <c:v>83.914297878821429</c:v>
                </c:pt>
                <c:pt idx="17">
                  <c:v>92.626574630426688</c:v>
                </c:pt>
                <c:pt idx="18">
                  <c:v>87.758302880147681</c:v>
                </c:pt>
                <c:pt idx="19">
                  <c:v>74.818725142231159</c:v>
                </c:pt>
                <c:pt idx="20">
                  <c:v>39.120088453126144</c:v>
                </c:pt>
                <c:pt idx="21">
                  <c:v>59.122620693823812</c:v>
                </c:pt>
                <c:pt idx="22">
                  <c:v>134.82832433998635</c:v>
                </c:pt>
                <c:pt idx="23">
                  <c:v>135.92015829533682</c:v>
                </c:pt>
                <c:pt idx="24">
                  <c:v>149.5826226610867</c:v>
                </c:pt>
                <c:pt idx="25">
                  <c:v>141.66928406068806</c:v>
                </c:pt>
                <c:pt idx="26">
                  <c:v>130.51901451370782</c:v>
                </c:pt>
                <c:pt idx="27">
                  <c:v>102.51558178387447</c:v>
                </c:pt>
                <c:pt idx="28">
                  <c:v>120.70488883731517</c:v>
                </c:pt>
                <c:pt idx="29">
                  <c:v>123.20694666296768</c:v>
                </c:pt>
                <c:pt idx="30">
                  <c:v>109.66261349419217</c:v>
                </c:pt>
                <c:pt idx="31">
                  <c:v>120.93938831916645</c:v>
                </c:pt>
                <c:pt idx="32">
                  <c:v>105.7835780101358</c:v>
                </c:pt>
                <c:pt idx="33">
                  <c:v>93.588249077434256</c:v>
                </c:pt>
                <c:pt idx="34">
                  <c:v>100.56243745146003</c:v>
                </c:pt>
                <c:pt idx="35">
                  <c:v>104.56283154905573</c:v>
                </c:pt>
                <c:pt idx="36">
                  <c:v>105.52045893601797</c:v>
                </c:pt>
                <c:pt idx="37">
                  <c:v>110.53868116794763</c:v>
                </c:pt>
                <c:pt idx="38">
                  <c:v>114.8239384354909</c:v>
                </c:pt>
                <c:pt idx="39">
                  <c:v>112.75086470666041</c:v>
                </c:pt>
                <c:pt idx="40">
                  <c:v>101.12192410645039</c:v>
                </c:pt>
                <c:pt idx="41">
                  <c:v>100.65513960835428</c:v>
                </c:pt>
                <c:pt idx="42">
                  <c:v>100.53047252328624</c:v>
                </c:pt>
                <c:pt idx="43">
                  <c:v>98.496845487978447</c:v>
                </c:pt>
                <c:pt idx="44">
                  <c:v>96.529937064254725</c:v>
                </c:pt>
                <c:pt idx="45">
                  <c:v>89.226151967762092</c:v>
                </c:pt>
                <c:pt idx="46">
                  <c:v>95.26003970190456</c:v>
                </c:pt>
                <c:pt idx="47">
                  <c:v>101.5138793647759</c:v>
                </c:pt>
                <c:pt idx="48">
                  <c:v>113.82142050183478</c:v>
                </c:pt>
                <c:pt idx="49">
                  <c:v>96.73171364608734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9492608"/>
        <c:axId val="189494400"/>
      </c:scatterChart>
      <c:valAx>
        <c:axId val="189492608"/>
        <c:scaling>
          <c:orientation val="minMax"/>
          <c:max val="800"/>
          <c:min val="-20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solidFill>
                  <a:schemeClr val="tx1"/>
                </a:solidFill>
              </a:defRPr>
            </a:pPr>
            <a:endParaRPr lang="en-US"/>
          </a:p>
        </c:txPr>
        <c:crossAx val="189494400"/>
        <c:crosses val="autoZero"/>
        <c:crossBetween val="midCat"/>
        <c:majorUnit val="200"/>
      </c:valAx>
      <c:valAx>
        <c:axId val="189494400"/>
        <c:scaling>
          <c:orientation val="minMax"/>
          <c:max val="400"/>
          <c:min val="-10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solidFill>
                  <a:schemeClr val="tx1"/>
                </a:solidFill>
              </a:defRPr>
            </a:pPr>
            <a:endParaRPr lang="en-US"/>
          </a:p>
        </c:txPr>
        <c:crossAx val="189492608"/>
        <c:crosses val="autoZero"/>
        <c:crossBetween val="midCat"/>
        <c:majorUnit val="100"/>
      </c:valAx>
    </c:plotArea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3"/>
            <c:spPr>
              <a:noFill/>
              <a:ln>
                <a:solidFill>
                  <a:schemeClr val="tx1"/>
                </a:solidFill>
              </a:ln>
            </c:spPr>
          </c:marker>
          <c:trendline>
            <c:spPr>
              <a:ln>
                <a:solidFill>
                  <a:schemeClr val="tx1"/>
                </a:solidFill>
              </a:ln>
            </c:spPr>
            <c:trendlineType val="linear"/>
            <c:dispRSqr val="1"/>
            <c:dispEq val="1"/>
            <c:trendlineLbl>
              <c:layout>
                <c:manualLayout>
                  <c:x val="0.1076954142166887"/>
                  <c:y val="-0.17218118218699263"/>
                </c:manualLayout>
              </c:layout>
              <c:tx>
                <c:rich>
                  <a:bodyPr/>
                  <a:lstStyle/>
                  <a:p>
                    <a:pPr>
                      <a:defRPr sz="1200">
                        <a:solidFill>
                          <a:schemeClr val="tx1"/>
                        </a:solidFill>
                      </a:defRPr>
                    </a:pPr>
                    <a:r>
                      <a:rPr lang="en-US" baseline="0" dirty="0" smtClean="0"/>
                      <a:t>Patient 7 </a:t>
                    </a:r>
                  </a:p>
                  <a:p>
                    <a:pPr>
                      <a:defRPr sz="1200">
                        <a:solidFill>
                          <a:schemeClr val="tx1"/>
                        </a:solidFill>
                      </a:defRPr>
                    </a:pPr>
                    <a:r>
                      <a:rPr lang="en-US" baseline="0" dirty="0" smtClean="0"/>
                      <a:t>r = 0.77</a:t>
                    </a:r>
                    <a:endParaRPr lang="en-US" dirty="0"/>
                  </a:p>
                </c:rich>
              </c:tx>
              <c:numFmt formatCode="General" sourceLinked="0"/>
            </c:trendlineLbl>
          </c:trendline>
          <c:xVal>
            <c:numRef>
              <c:f>Sheet3!$L$19:$L$162</c:f>
              <c:numCache>
                <c:formatCode>General</c:formatCode>
                <c:ptCount val="144"/>
                <c:pt idx="1">
                  <c:v>70.216769230769216</c:v>
                </c:pt>
                <c:pt idx="2">
                  <c:v>95.582923076923052</c:v>
                </c:pt>
                <c:pt idx="3">
                  <c:v>123.45953846153847</c:v>
                </c:pt>
                <c:pt idx="4">
                  <c:v>158.68846153846158</c:v>
                </c:pt>
                <c:pt idx="5">
                  <c:v>196.7367692307692</c:v>
                </c:pt>
                <c:pt idx="6">
                  <c:v>-223.57338461538498</c:v>
                </c:pt>
                <c:pt idx="7">
                  <c:v>-224.308769230769</c:v>
                </c:pt>
                <c:pt idx="8">
                  <c:v>-216.40492307692301</c:v>
                </c:pt>
                <c:pt idx="9">
                  <c:v>-210.52323076923099</c:v>
                </c:pt>
                <c:pt idx="10">
                  <c:v>-213.036</c:v>
                </c:pt>
                <c:pt idx="11">
                  <c:v>-207.21538461538498</c:v>
                </c:pt>
                <c:pt idx="12">
                  <c:v>-187.547384615385</c:v>
                </c:pt>
                <c:pt idx="13">
                  <c:v>-168.06415384615397</c:v>
                </c:pt>
                <c:pt idx="14">
                  <c:v>-153.666</c:v>
                </c:pt>
                <c:pt idx="15">
                  <c:v>-132.83415384615398</c:v>
                </c:pt>
                <c:pt idx="16">
                  <c:v>-110.47046153846199</c:v>
                </c:pt>
                <c:pt idx="17">
                  <c:v>-95.765846153846184</c:v>
                </c:pt>
                <c:pt idx="18">
                  <c:v>-84.063846153846185</c:v>
                </c:pt>
                <c:pt idx="19">
                  <c:v>-65.621692307692285</c:v>
                </c:pt>
                <c:pt idx="20">
                  <c:v>-45.464307692307692</c:v>
                </c:pt>
                <c:pt idx="21">
                  <c:v>-36.458153846153813</c:v>
                </c:pt>
                <c:pt idx="22">
                  <c:v>-35.845692307692289</c:v>
                </c:pt>
                <c:pt idx="24">
                  <c:v>40.991538461538454</c:v>
                </c:pt>
                <c:pt idx="25">
                  <c:v>44.29984615384614</c:v>
                </c:pt>
                <c:pt idx="26">
                  <c:v>48.650307692307685</c:v>
                </c:pt>
                <c:pt idx="27">
                  <c:v>55.08261538461538</c:v>
                </c:pt>
                <c:pt idx="28">
                  <c:v>64.089384615384589</c:v>
                </c:pt>
                <c:pt idx="29">
                  <c:v>82.470923076923071</c:v>
                </c:pt>
                <c:pt idx="30">
                  <c:v>114.02523076923077</c:v>
                </c:pt>
                <c:pt idx="31">
                  <c:v>157.8929230769231</c:v>
                </c:pt>
                <c:pt idx="32">
                  <c:v>204.3349230769231</c:v>
                </c:pt>
                <c:pt idx="33">
                  <c:v>237.72738461538461</c:v>
                </c:pt>
                <c:pt idx="34">
                  <c:v>254.14753846153843</c:v>
                </c:pt>
                <c:pt idx="35">
                  <c:v>265.11523076923066</c:v>
                </c:pt>
                <c:pt idx="36">
                  <c:v>262.90938461538462</c:v>
                </c:pt>
                <c:pt idx="37">
                  <c:v>249.55261538461539</c:v>
                </c:pt>
                <c:pt idx="38">
                  <c:v>225.90215384615385</c:v>
                </c:pt>
                <c:pt idx="39">
                  <c:v>198.2083076923077</c:v>
                </c:pt>
                <c:pt idx="40">
                  <c:v>174.06830769230771</c:v>
                </c:pt>
                <c:pt idx="41">
                  <c:v>152.2563076923077</c:v>
                </c:pt>
                <c:pt idx="42">
                  <c:v>127.07338461538461</c:v>
                </c:pt>
                <c:pt idx="43">
                  <c:v>104.28153846153847</c:v>
                </c:pt>
                <c:pt idx="44">
                  <c:v>85.043538461538461</c:v>
                </c:pt>
                <c:pt idx="45">
                  <c:v>74.873538461538459</c:v>
                </c:pt>
                <c:pt idx="46">
                  <c:v>69.54307692307691</c:v>
                </c:pt>
                <c:pt idx="47">
                  <c:v>70.890923076923073</c:v>
                </c:pt>
                <c:pt idx="48">
                  <c:v>72.300307692307683</c:v>
                </c:pt>
                <c:pt idx="49">
                  <c:v>84.248153846153812</c:v>
                </c:pt>
                <c:pt idx="50">
                  <c:v>91.11015384615385</c:v>
                </c:pt>
                <c:pt idx="51">
                  <c:v>97.788461538461505</c:v>
                </c:pt>
                <c:pt idx="52">
                  <c:v>103.36369230769229</c:v>
                </c:pt>
                <c:pt idx="53">
                  <c:v>106.91738461538462</c:v>
                </c:pt>
                <c:pt idx="54">
                  <c:v>108.38784615384616</c:v>
                </c:pt>
                <c:pt idx="55">
                  <c:v>108.93938461538461</c:v>
                </c:pt>
                <c:pt idx="56">
                  <c:v>109.06184615384615</c:v>
                </c:pt>
                <c:pt idx="57">
                  <c:v>109.00046153846152</c:v>
                </c:pt>
                <c:pt idx="58">
                  <c:v>108.2652307692308</c:v>
                </c:pt>
                <c:pt idx="59">
                  <c:v>106.61076923076921</c:v>
                </c:pt>
                <c:pt idx="60">
                  <c:v>103.48584615384614</c:v>
                </c:pt>
                <c:pt idx="61">
                  <c:v>98.706769230769211</c:v>
                </c:pt>
                <c:pt idx="62">
                  <c:v>92.947076923076935</c:v>
                </c:pt>
                <c:pt idx="63">
                  <c:v>87.371538461538449</c:v>
                </c:pt>
                <c:pt idx="64">
                  <c:v>82.286307692307687</c:v>
                </c:pt>
                <c:pt idx="65">
                  <c:v>77.813692307692293</c:v>
                </c:pt>
                <c:pt idx="66">
                  <c:v>74.260153846153841</c:v>
                </c:pt>
                <c:pt idx="67">
                  <c:v>72.172230769230751</c:v>
                </c:pt>
                <c:pt idx="68">
                  <c:v>70.216307692307694</c:v>
                </c:pt>
                <c:pt idx="69">
                  <c:v>68.715461538461525</c:v>
                </c:pt>
                <c:pt idx="70">
                  <c:v>67.020499999999998</c:v>
                </c:pt>
                <c:pt idx="71">
                  <c:v>64.675954545454516</c:v>
                </c:pt>
                <c:pt idx="72">
                  <c:v>61.84604545454544</c:v>
                </c:pt>
                <c:pt idx="73">
                  <c:v>59.318136363636349</c:v>
                </c:pt>
                <c:pt idx="74">
                  <c:v>56.05233636363635</c:v>
                </c:pt>
                <c:pt idx="75">
                  <c:v>51.107836363636345</c:v>
                </c:pt>
              </c:numCache>
            </c:numRef>
          </c:xVal>
          <c:yVal>
            <c:numRef>
              <c:f>Sheet3!$J$19:$J$162</c:f>
              <c:numCache>
                <c:formatCode>General</c:formatCode>
                <c:ptCount val="144"/>
                <c:pt idx="0">
                  <c:v>77.819100023730414</c:v>
                </c:pt>
                <c:pt idx="1">
                  <c:v>63.867685746173478</c:v>
                </c:pt>
                <c:pt idx="2">
                  <c:v>58.213851947028822</c:v>
                </c:pt>
                <c:pt idx="3">
                  <c:v>46.841502526491361</c:v>
                </c:pt>
                <c:pt idx="4">
                  <c:v>30.7863850111804</c:v>
                </c:pt>
                <c:pt idx="5">
                  <c:v>47.38015808515101</c:v>
                </c:pt>
                <c:pt idx="6">
                  <c:v>-26.900955694777913</c:v>
                </c:pt>
                <c:pt idx="7">
                  <c:v>-67.757241635878501</c:v>
                </c:pt>
                <c:pt idx="8">
                  <c:v>-82.686122268968063</c:v>
                </c:pt>
                <c:pt idx="9">
                  <c:v>-74.110590897033589</c:v>
                </c:pt>
                <c:pt idx="10">
                  <c:v>-79.851967947823653</c:v>
                </c:pt>
                <c:pt idx="11">
                  <c:v>-97.699431335033978</c:v>
                </c:pt>
                <c:pt idx="12">
                  <c:v>-96.953427061742687</c:v>
                </c:pt>
                <c:pt idx="13">
                  <c:v>-103.34033162804498</c:v>
                </c:pt>
                <c:pt idx="14">
                  <c:v>-101.87963302860931</c:v>
                </c:pt>
                <c:pt idx="15">
                  <c:v>-89.310744290334242</c:v>
                </c:pt>
                <c:pt idx="16">
                  <c:v>-86.120234822206314</c:v>
                </c:pt>
                <c:pt idx="17">
                  <c:v>-74.941905206263044</c:v>
                </c:pt>
                <c:pt idx="18">
                  <c:v>-67.031983400769263</c:v>
                </c:pt>
                <c:pt idx="19">
                  <c:v>-57.126691822562357</c:v>
                </c:pt>
                <c:pt idx="20">
                  <c:v>-40.251898005794537</c:v>
                </c:pt>
                <c:pt idx="21">
                  <c:v>-21.589436218991899</c:v>
                </c:pt>
                <c:pt idx="22">
                  <c:v>-22.034075126644268</c:v>
                </c:pt>
                <c:pt idx="24">
                  <c:v>18.000755760774705</c:v>
                </c:pt>
                <c:pt idx="25">
                  <c:v>43.113608828487152</c:v>
                </c:pt>
                <c:pt idx="26">
                  <c:v>52.736076756296704</c:v>
                </c:pt>
                <c:pt idx="27">
                  <c:v>57.483502665213024</c:v>
                </c:pt>
                <c:pt idx="28">
                  <c:v>76.934092982799555</c:v>
                </c:pt>
                <c:pt idx="29">
                  <c:v>105.84929935515872</c:v>
                </c:pt>
                <c:pt idx="30">
                  <c:v>128.64300723343081</c:v>
                </c:pt>
                <c:pt idx="31">
                  <c:v>159.14175086152878</c:v>
                </c:pt>
                <c:pt idx="32">
                  <c:v>191.71848426870741</c:v>
                </c:pt>
                <c:pt idx="33">
                  <c:v>207.11336625381685</c:v>
                </c:pt>
                <c:pt idx="34">
                  <c:v>197.52085562047398</c:v>
                </c:pt>
                <c:pt idx="35">
                  <c:v>194.50798318384463</c:v>
                </c:pt>
                <c:pt idx="36">
                  <c:v>189.24034457533014</c:v>
                </c:pt>
                <c:pt idx="37">
                  <c:v>187.09586699263042</c:v>
                </c:pt>
                <c:pt idx="38">
                  <c:v>178.8419734286723</c:v>
                </c:pt>
                <c:pt idx="39">
                  <c:v>155.98577085093598</c:v>
                </c:pt>
                <c:pt idx="40">
                  <c:v>150.41051466579572</c:v>
                </c:pt>
                <c:pt idx="41">
                  <c:v>143.80546612928143</c:v>
                </c:pt>
                <c:pt idx="42">
                  <c:v>153.25682629402564</c:v>
                </c:pt>
                <c:pt idx="43">
                  <c:v>151.16069592927627</c:v>
                </c:pt>
                <c:pt idx="44">
                  <c:v>140.0307422846704</c:v>
                </c:pt>
                <c:pt idx="45">
                  <c:v>131.97948314525462</c:v>
                </c:pt>
                <c:pt idx="46">
                  <c:v>114.94418307467625</c:v>
                </c:pt>
                <c:pt idx="47">
                  <c:v>117.99171950704745</c:v>
                </c:pt>
                <c:pt idx="48">
                  <c:v>86.985549994454288</c:v>
                </c:pt>
                <c:pt idx="49">
                  <c:v>75.78945662374867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9510784"/>
        <c:axId val="189512320"/>
      </c:scatterChart>
      <c:valAx>
        <c:axId val="189510784"/>
        <c:scaling>
          <c:orientation val="minMax"/>
          <c:max val="600"/>
          <c:min val="-20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solidFill>
                  <a:schemeClr val="tx1"/>
                </a:solidFill>
              </a:defRPr>
            </a:pPr>
            <a:endParaRPr lang="en-US"/>
          </a:p>
        </c:txPr>
        <c:crossAx val="189512320"/>
        <c:crosses val="autoZero"/>
        <c:crossBetween val="midCat"/>
        <c:majorUnit val="200"/>
      </c:valAx>
      <c:valAx>
        <c:axId val="189512320"/>
        <c:scaling>
          <c:orientation val="minMax"/>
          <c:max val="300"/>
          <c:min val="-10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solidFill>
                  <a:schemeClr val="tx1"/>
                </a:solidFill>
              </a:defRPr>
            </a:pPr>
            <a:endParaRPr lang="en-US"/>
          </a:p>
        </c:txPr>
        <c:crossAx val="189510784"/>
        <c:crosses val="autoZero"/>
        <c:crossBetween val="midCat"/>
        <c:majorUnit val="100"/>
      </c:valAx>
    </c:plotArea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3"/>
            <c:spPr>
              <a:noFill/>
              <a:ln>
                <a:solidFill>
                  <a:schemeClr val="tx1"/>
                </a:solidFill>
              </a:ln>
            </c:spPr>
          </c:marker>
          <c:trendline>
            <c:spPr>
              <a:ln>
                <a:solidFill>
                  <a:schemeClr val="tx1"/>
                </a:solidFill>
              </a:ln>
            </c:spPr>
            <c:trendlineType val="linear"/>
            <c:dispRSqr val="1"/>
            <c:dispEq val="1"/>
            <c:trendlineLbl>
              <c:layout>
                <c:manualLayout>
                  <c:x val="-0.16015532192919935"/>
                  <c:y val="-0.34230804736034137"/>
                </c:manualLayout>
              </c:layout>
              <c:tx>
                <c:rich>
                  <a:bodyPr/>
                  <a:lstStyle/>
                  <a:p>
                    <a:pPr>
                      <a:defRPr sz="1200">
                        <a:solidFill>
                          <a:schemeClr val="tx1"/>
                        </a:solidFill>
                      </a:defRPr>
                    </a:pPr>
                    <a:r>
                      <a:rPr lang="en-US" baseline="0" dirty="0" smtClean="0"/>
                      <a:t>Patient 4 </a:t>
                    </a:r>
                  </a:p>
                  <a:p>
                    <a:pPr>
                      <a:defRPr sz="1200">
                        <a:solidFill>
                          <a:schemeClr val="tx1"/>
                        </a:solidFill>
                      </a:defRPr>
                    </a:pPr>
                    <a:r>
                      <a:rPr lang="en-US" baseline="0" dirty="0" smtClean="0"/>
                      <a:t>r </a:t>
                    </a:r>
                    <a:r>
                      <a:rPr lang="en-US" baseline="0" dirty="0"/>
                      <a:t>= </a:t>
                    </a:r>
                    <a:r>
                      <a:rPr lang="en-US" baseline="0" dirty="0" smtClean="0"/>
                      <a:t>0.95</a:t>
                    </a:r>
                    <a:endParaRPr lang="en-US" dirty="0"/>
                  </a:p>
                </c:rich>
              </c:tx>
              <c:numFmt formatCode="General" sourceLinked="0"/>
            </c:trendlineLbl>
          </c:trendline>
          <c:xVal>
            <c:numRef>
              <c:f>Sheet6!$E$252:$E$294</c:f>
              <c:numCache>
                <c:formatCode>General</c:formatCode>
                <c:ptCount val="43"/>
                <c:pt idx="0">
                  <c:v>514.4141666666668</c:v>
                </c:pt>
                <c:pt idx="1">
                  <c:v>408.8725</c:v>
                </c:pt>
                <c:pt idx="2">
                  <c:v>233.6408333333334</c:v>
                </c:pt>
                <c:pt idx="3">
                  <c:v>172.57583333333335</c:v>
                </c:pt>
                <c:pt idx="5">
                  <c:v>160.6</c:v>
                </c:pt>
                <c:pt idx="6">
                  <c:v>142.04416666666665</c:v>
                </c:pt>
                <c:pt idx="7">
                  <c:v>146.69999999999999</c:v>
                </c:pt>
                <c:pt idx="19">
                  <c:v>175.89416666666665</c:v>
                </c:pt>
                <c:pt idx="20">
                  <c:v>211.73749999999998</c:v>
                </c:pt>
                <c:pt idx="21">
                  <c:v>273.4666666666667</c:v>
                </c:pt>
                <c:pt idx="22">
                  <c:v>414.18249999999995</c:v>
                </c:pt>
                <c:pt idx="23">
                  <c:v>532.99916666666684</c:v>
                </c:pt>
                <c:pt idx="24">
                  <c:v>598.0474999999999</c:v>
                </c:pt>
                <c:pt idx="25">
                  <c:v>595.39249999999993</c:v>
                </c:pt>
                <c:pt idx="26">
                  <c:v>603.35833333333335</c:v>
                </c:pt>
                <c:pt idx="27">
                  <c:v>613.31416666666678</c:v>
                </c:pt>
                <c:pt idx="28">
                  <c:v>633.89083333333338</c:v>
                </c:pt>
                <c:pt idx="29">
                  <c:v>660.43999999999983</c:v>
                </c:pt>
                <c:pt idx="30">
                  <c:v>688.3175</c:v>
                </c:pt>
                <c:pt idx="31">
                  <c:v>693.62666666666678</c:v>
                </c:pt>
                <c:pt idx="32">
                  <c:v>700.26583333333349</c:v>
                </c:pt>
                <c:pt idx="33">
                  <c:v>684.33499999999981</c:v>
                </c:pt>
                <c:pt idx="34">
                  <c:v>677.69833333333361</c:v>
                </c:pt>
                <c:pt idx="35">
                  <c:v>671.72416666666686</c:v>
                </c:pt>
                <c:pt idx="36">
                  <c:v>671.06000000000006</c:v>
                </c:pt>
                <c:pt idx="37">
                  <c:v>636.54583333333335</c:v>
                </c:pt>
                <c:pt idx="38">
                  <c:v>562.20499999999993</c:v>
                </c:pt>
                <c:pt idx="39">
                  <c:v>531.67250000000001</c:v>
                </c:pt>
                <c:pt idx="40">
                  <c:v>542.95749999999998</c:v>
                </c:pt>
                <c:pt idx="41">
                  <c:v>548.93083333333334</c:v>
                </c:pt>
                <c:pt idx="42">
                  <c:v>537.28454545454554</c:v>
                </c:pt>
              </c:numCache>
            </c:numRef>
          </c:xVal>
          <c:yVal>
            <c:numRef>
              <c:f>Sheet6!$F$252:$F$294</c:f>
              <c:numCache>
                <c:formatCode>General</c:formatCode>
                <c:ptCount val="43"/>
                <c:pt idx="0">
                  <c:v>92.639758322935549</c:v>
                </c:pt>
                <c:pt idx="1">
                  <c:v>74.61051753001847</c:v>
                </c:pt>
                <c:pt idx="2">
                  <c:v>58.873669854525865</c:v>
                </c:pt>
                <c:pt idx="3">
                  <c:v>33.253974419135545</c:v>
                </c:pt>
                <c:pt idx="5">
                  <c:v>15.9391184086629</c:v>
                </c:pt>
                <c:pt idx="6">
                  <c:v>45.860871550324667</c:v>
                </c:pt>
                <c:pt idx="7">
                  <c:v>21.582857289708642</c:v>
                </c:pt>
                <c:pt idx="19">
                  <c:v>33.731310348791389</c:v>
                </c:pt>
                <c:pt idx="20">
                  <c:v>58.936571864542131</c:v>
                </c:pt>
                <c:pt idx="21">
                  <c:v>85.402797122185873</c:v>
                </c:pt>
                <c:pt idx="22">
                  <c:v>94.100798957065678</c:v>
                </c:pt>
                <c:pt idx="23">
                  <c:v>127.53696795615301</c:v>
                </c:pt>
                <c:pt idx="24">
                  <c:v>156.28651650474293</c:v>
                </c:pt>
                <c:pt idx="25">
                  <c:v>174.07878766741075</c:v>
                </c:pt>
                <c:pt idx="26">
                  <c:v>159.71662248883928</c:v>
                </c:pt>
                <c:pt idx="27">
                  <c:v>155.31654575892858</c:v>
                </c:pt>
                <c:pt idx="28">
                  <c:v>149.15355335582385</c:v>
                </c:pt>
                <c:pt idx="29">
                  <c:v>153.2309802827381</c:v>
                </c:pt>
                <c:pt idx="30">
                  <c:v>158.21135764898256</c:v>
                </c:pt>
                <c:pt idx="31">
                  <c:v>162.72002392618441</c:v>
                </c:pt>
                <c:pt idx="32">
                  <c:v>150.82198660714286</c:v>
                </c:pt>
                <c:pt idx="33">
                  <c:v>156.30547626201925</c:v>
                </c:pt>
                <c:pt idx="34">
                  <c:v>135.39965503246751</c:v>
                </c:pt>
                <c:pt idx="35">
                  <c:v>135.2701400162338</c:v>
                </c:pt>
                <c:pt idx="36">
                  <c:v>134.12558340097405</c:v>
                </c:pt>
                <c:pt idx="37">
                  <c:v>138.10186298076923</c:v>
                </c:pt>
                <c:pt idx="38">
                  <c:v>126.23573521205354</c:v>
                </c:pt>
                <c:pt idx="39">
                  <c:v>127.16339983258925</c:v>
                </c:pt>
                <c:pt idx="40">
                  <c:v>126.33463052161653</c:v>
                </c:pt>
                <c:pt idx="41">
                  <c:v>122.91679393796993</c:v>
                </c:pt>
                <c:pt idx="42">
                  <c:v>132.2793193247126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2167296"/>
        <c:axId val="192177280"/>
      </c:scatterChart>
      <c:valAx>
        <c:axId val="192167296"/>
        <c:scaling>
          <c:orientation val="minMax"/>
          <c:max val="800"/>
          <c:min val="-20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solidFill>
                  <a:schemeClr val="tx1"/>
                </a:solidFill>
              </a:defRPr>
            </a:pPr>
            <a:endParaRPr lang="en-US"/>
          </a:p>
        </c:txPr>
        <c:crossAx val="192177280"/>
        <c:crosses val="autoZero"/>
        <c:crossBetween val="midCat"/>
        <c:majorUnit val="200"/>
      </c:valAx>
      <c:valAx>
        <c:axId val="192177280"/>
        <c:scaling>
          <c:orientation val="minMax"/>
          <c:max val="400"/>
          <c:min val="-10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solidFill>
                  <a:schemeClr val="tx1"/>
                </a:solidFill>
              </a:defRPr>
            </a:pPr>
            <a:endParaRPr lang="en-US"/>
          </a:p>
        </c:txPr>
        <c:crossAx val="192167296"/>
        <c:crosses val="autoZero"/>
        <c:crossBetween val="midCat"/>
        <c:majorUnit val="100"/>
      </c:valAx>
    </c:plotArea>
    <c:plotVisOnly val="1"/>
    <c:dispBlanksAs val="gap"/>
    <c:showDLblsOverMax val="0"/>
  </c:chart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3"/>
            <c:spPr>
              <a:noFill/>
              <a:ln>
                <a:solidFill>
                  <a:schemeClr val="tx1"/>
                </a:solidFill>
              </a:ln>
            </c:spPr>
          </c:marker>
          <c:trendline>
            <c:spPr>
              <a:ln>
                <a:solidFill>
                  <a:schemeClr val="tx1"/>
                </a:solidFill>
              </a:ln>
            </c:spPr>
            <c:trendlineType val="linear"/>
            <c:dispRSqr val="1"/>
            <c:dispEq val="1"/>
            <c:trendlineLbl>
              <c:layout>
                <c:manualLayout>
                  <c:x val="-4.2617541492719679E-2"/>
                  <c:y val="-7.2946479025747052E-2"/>
                </c:manualLayout>
              </c:layout>
              <c:tx>
                <c:rich>
                  <a:bodyPr/>
                  <a:lstStyle/>
                  <a:p>
                    <a:pPr>
                      <a:defRPr sz="1200">
                        <a:solidFill>
                          <a:schemeClr val="tx1"/>
                        </a:solidFill>
                      </a:defRPr>
                    </a:pPr>
                    <a:r>
                      <a:rPr lang="en-US" baseline="0" dirty="0" smtClean="0"/>
                      <a:t>Patient 5 </a:t>
                    </a:r>
                  </a:p>
                  <a:p>
                    <a:pPr>
                      <a:defRPr sz="1200">
                        <a:solidFill>
                          <a:schemeClr val="tx1"/>
                        </a:solidFill>
                      </a:defRPr>
                    </a:pPr>
                    <a:r>
                      <a:rPr lang="en-US" baseline="0" dirty="0" smtClean="0"/>
                      <a:t> r </a:t>
                    </a:r>
                    <a:r>
                      <a:rPr lang="en-US" baseline="0" dirty="0"/>
                      <a:t>= </a:t>
                    </a:r>
                    <a:r>
                      <a:rPr lang="en-US" baseline="0" dirty="0" smtClean="0"/>
                      <a:t>0.95</a:t>
                    </a:r>
                    <a:endParaRPr lang="en-US" dirty="0"/>
                  </a:p>
                </c:rich>
              </c:tx>
              <c:numFmt formatCode="General" sourceLinked="0"/>
            </c:trendlineLbl>
          </c:trendline>
          <c:xVal>
            <c:numRef>
              <c:f>Sheet6!$C$290:$C$339</c:f>
              <c:numCache>
                <c:formatCode>General</c:formatCode>
                <c:ptCount val="50"/>
                <c:pt idx="1">
                  <c:v>220.10999999999999</c:v>
                </c:pt>
                <c:pt idx="2">
                  <c:v>140.70825000000002</c:v>
                </c:pt>
                <c:pt idx="3">
                  <c:v>140.90675000000002</c:v>
                </c:pt>
                <c:pt idx="4">
                  <c:v>165.49900000000002</c:v>
                </c:pt>
                <c:pt idx="5">
                  <c:v>131.22462499999995</c:v>
                </c:pt>
                <c:pt idx="6">
                  <c:v>99.165125000000003</c:v>
                </c:pt>
                <c:pt idx="7">
                  <c:v>77.684750000000008</c:v>
                </c:pt>
                <c:pt idx="8">
                  <c:v>79.103374999999986</c:v>
                </c:pt>
                <c:pt idx="9">
                  <c:v>75.444500000000019</c:v>
                </c:pt>
                <c:pt idx="10">
                  <c:v>55.85575</c:v>
                </c:pt>
                <c:pt idx="11">
                  <c:v>38.955000000000005</c:v>
                </c:pt>
                <c:pt idx="12">
                  <c:v>37.611000000000004</c:v>
                </c:pt>
                <c:pt idx="13">
                  <c:v>39.925750000000015</c:v>
                </c:pt>
                <c:pt idx="14">
                  <c:v>80.223749999999981</c:v>
                </c:pt>
                <c:pt idx="15">
                  <c:v>96.253749999999968</c:v>
                </c:pt>
                <c:pt idx="16">
                  <c:v>136.15349999999998</c:v>
                </c:pt>
                <c:pt idx="17">
                  <c:v>188.64837499999999</c:v>
                </c:pt>
                <c:pt idx="18">
                  <c:v>124.20562500000003</c:v>
                </c:pt>
                <c:pt idx="19">
                  <c:v>98.692749999999975</c:v>
                </c:pt>
                <c:pt idx="20">
                  <c:v>117.50987499999998</c:v>
                </c:pt>
                <c:pt idx="21">
                  <c:v>153.70112499999999</c:v>
                </c:pt>
                <c:pt idx="22">
                  <c:v>202.412125</c:v>
                </c:pt>
                <c:pt idx="23">
                  <c:v>283.55650000000003</c:v>
                </c:pt>
                <c:pt idx="24">
                  <c:v>391.23462500000005</c:v>
                </c:pt>
                <c:pt idx="25">
                  <c:v>440.39462500000002</c:v>
                </c:pt>
                <c:pt idx="26">
                  <c:v>473.77387499999992</c:v>
                </c:pt>
                <c:pt idx="27">
                  <c:v>497.14712500000007</c:v>
                </c:pt>
                <c:pt idx="28">
                  <c:v>526.6681249999998</c:v>
                </c:pt>
                <c:pt idx="29">
                  <c:v>555.69062499999984</c:v>
                </c:pt>
                <c:pt idx="30">
                  <c:v>563.63024999999982</c:v>
                </c:pt>
                <c:pt idx="31">
                  <c:v>553.89812499999982</c:v>
                </c:pt>
                <c:pt idx="32">
                  <c:v>547.97424999999998</c:v>
                </c:pt>
                <c:pt idx="33">
                  <c:v>529.60487500000022</c:v>
                </c:pt>
                <c:pt idx="34">
                  <c:v>528.90749999999991</c:v>
                </c:pt>
                <c:pt idx="35">
                  <c:v>530.84850000000006</c:v>
                </c:pt>
                <c:pt idx="36">
                  <c:v>532.69075000000009</c:v>
                </c:pt>
                <c:pt idx="37">
                  <c:v>533.26362499999993</c:v>
                </c:pt>
                <c:pt idx="38">
                  <c:v>514.37162499999999</c:v>
                </c:pt>
                <c:pt idx="39">
                  <c:v>515.16875000000005</c:v>
                </c:pt>
                <c:pt idx="40">
                  <c:v>520.71899999999994</c:v>
                </c:pt>
                <c:pt idx="41">
                  <c:v>513.77450000000022</c:v>
                </c:pt>
                <c:pt idx="42">
                  <c:v>503.1953749999999</c:v>
                </c:pt>
                <c:pt idx="43">
                  <c:v>509.86612499999984</c:v>
                </c:pt>
                <c:pt idx="44">
                  <c:v>503.86775000000006</c:v>
                </c:pt>
                <c:pt idx="45">
                  <c:v>491.49712499999987</c:v>
                </c:pt>
                <c:pt idx="46">
                  <c:v>490.452</c:v>
                </c:pt>
                <c:pt idx="47">
                  <c:v>484.76431666666679</c:v>
                </c:pt>
                <c:pt idx="48">
                  <c:v>475.14453333333347</c:v>
                </c:pt>
                <c:pt idx="49">
                  <c:v>452.52386666666672</c:v>
                </c:pt>
              </c:numCache>
            </c:numRef>
          </c:xVal>
          <c:yVal>
            <c:numRef>
              <c:f>Sheet6!$B$290:$B$339</c:f>
              <c:numCache>
                <c:formatCode>General</c:formatCode>
                <c:ptCount val="50"/>
                <c:pt idx="0">
                  <c:v>171.27707506613751</c:v>
                </c:pt>
                <c:pt idx="1">
                  <c:v>146.63934281089524</c:v>
                </c:pt>
                <c:pt idx="2">
                  <c:v>136.95835306186865</c:v>
                </c:pt>
                <c:pt idx="3">
                  <c:v>131.59671089305002</c:v>
                </c:pt>
                <c:pt idx="4">
                  <c:v>115.56787550671184</c:v>
                </c:pt>
                <c:pt idx="5">
                  <c:v>46.589251448934832</c:v>
                </c:pt>
                <c:pt idx="6">
                  <c:v>-27.40072604008358</c:v>
                </c:pt>
                <c:pt idx="7">
                  <c:v>-34.729912148189307</c:v>
                </c:pt>
                <c:pt idx="8">
                  <c:v>-21.431767873781208</c:v>
                </c:pt>
                <c:pt idx="9">
                  <c:v>-7.0693661236424408</c:v>
                </c:pt>
                <c:pt idx="10">
                  <c:v>-18.55874840886931</c:v>
                </c:pt>
                <c:pt idx="11">
                  <c:v>-44.272153818913949</c:v>
                </c:pt>
                <c:pt idx="12">
                  <c:v>-54.098921415530334</c:v>
                </c:pt>
                <c:pt idx="13">
                  <c:v>-33.721684854497347</c:v>
                </c:pt>
                <c:pt idx="14">
                  <c:v>-16.779284766349676</c:v>
                </c:pt>
                <c:pt idx="15">
                  <c:v>-28.744512511565119</c:v>
                </c:pt>
                <c:pt idx="16">
                  <c:v>-24.082195351411581</c:v>
                </c:pt>
                <c:pt idx="17">
                  <c:v>-2.6840990163796015</c:v>
                </c:pt>
                <c:pt idx="18">
                  <c:v>-0.93045138803171923</c:v>
                </c:pt>
                <c:pt idx="19">
                  <c:v>-2.3286096650801835</c:v>
                </c:pt>
                <c:pt idx="20">
                  <c:v>4.9413631835506866</c:v>
                </c:pt>
                <c:pt idx="21">
                  <c:v>28.447450352004218</c:v>
                </c:pt>
                <c:pt idx="22">
                  <c:v>53.270117383758418</c:v>
                </c:pt>
                <c:pt idx="23">
                  <c:v>64.389387672291619</c:v>
                </c:pt>
                <c:pt idx="24">
                  <c:v>90.878887267774346</c:v>
                </c:pt>
                <c:pt idx="25">
                  <c:v>140.96605453955607</c:v>
                </c:pt>
                <c:pt idx="26">
                  <c:v>185.23762921417418</c:v>
                </c:pt>
                <c:pt idx="27">
                  <c:v>209.29465835655685</c:v>
                </c:pt>
                <c:pt idx="28">
                  <c:v>250.50860062386221</c:v>
                </c:pt>
                <c:pt idx="29">
                  <c:v>292.44687832270068</c:v>
                </c:pt>
                <c:pt idx="30">
                  <c:v>301.06085037683346</c:v>
                </c:pt>
                <c:pt idx="31">
                  <c:v>290.54546001639295</c:v>
                </c:pt>
                <c:pt idx="32">
                  <c:v>276.56198855015487</c:v>
                </c:pt>
                <c:pt idx="33">
                  <c:v>278.25699946890825</c:v>
                </c:pt>
                <c:pt idx="34">
                  <c:v>257.15843184550158</c:v>
                </c:pt>
                <c:pt idx="35">
                  <c:v>276.27520283588166</c:v>
                </c:pt>
                <c:pt idx="36">
                  <c:v>239.39072511182303</c:v>
                </c:pt>
                <c:pt idx="37">
                  <c:v>243.86784237470241</c:v>
                </c:pt>
                <c:pt idx="38">
                  <c:v>232.33250594993183</c:v>
                </c:pt>
                <c:pt idx="39">
                  <c:v>217.9335507470951</c:v>
                </c:pt>
                <c:pt idx="40">
                  <c:v>251.76630395968382</c:v>
                </c:pt>
                <c:pt idx="41">
                  <c:v>225.67938738131596</c:v>
                </c:pt>
                <c:pt idx="42">
                  <c:v>215.73503513125362</c:v>
                </c:pt>
                <c:pt idx="43">
                  <c:v>213.49660495292977</c:v>
                </c:pt>
                <c:pt idx="44">
                  <c:v>223.3979015614446</c:v>
                </c:pt>
                <c:pt idx="45">
                  <c:v>222.61375919090753</c:v>
                </c:pt>
                <c:pt idx="46">
                  <c:v>206.7438932559642</c:v>
                </c:pt>
                <c:pt idx="47">
                  <c:v>209.88428674328776</c:v>
                </c:pt>
                <c:pt idx="48">
                  <c:v>206.5000513271396</c:v>
                </c:pt>
                <c:pt idx="49">
                  <c:v>195.6471015250821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2205568"/>
        <c:axId val="192207104"/>
      </c:scatterChart>
      <c:valAx>
        <c:axId val="192205568"/>
        <c:scaling>
          <c:orientation val="minMax"/>
          <c:max val="800"/>
          <c:min val="-20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solidFill>
                  <a:schemeClr val="tx1"/>
                </a:solidFill>
              </a:defRPr>
            </a:pPr>
            <a:endParaRPr lang="en-US"/>
          </a:p>
        </c:txPr>
        <c:crossAx val="192207104"/>
        <c:crosses val="autoZero"/>
        <c:crossBetween val="midCat"/>
        <c:majorUnit val="200"/>
      </c:valAx>
      <c:valAx>
        <c:axId val="192207104"/>
        <c:scaling>
          <c:orientation val="minMax"/>
          <c:max val="400"/>
          <c:min val="-10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solidFill>
                  <a:schemeClr val="tx1"/>
                </a:solidFill>
              </a:defRPr>
            </a:pPr>
            <a:endParaRPr lang="en-US"/>
          </a:p>
        </c:txPr>
        <c:crossAx val="192205568"/>
        <c:crosses val="autoZero"/>
        <c:crossBetween val="midCat"/>
        <c:majorUnit val="100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77EB6E6-1B63-4D9E-912E-1DD412936FD7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E697F41-13F5-4C7F-B067-4836EC3E9E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32526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Figure</a:t>
            </a:r>
            <a:r>
              <a:rPr lang="en-US" baseline="0" dirty="0" smtClean="0"/>
              <a:t> S3: </a:t>
            </a:r>
            <a:r>
              <a:rPr lang="en-US" dirty="0" smtClean="0"/>
              <a:t>Comparison</a:t>
            </a:r>
            <a:r>
              <a:rPr lang="en-US" baseline="0" dirty="0" smtClean="0"/>
              <a:t> of invasive and CMR flow velocity reading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5189144-3BD1-4F7B-8437-23D507DCB359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1F787-034B-4F87-A938-5B1D18C62661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63569-7B5D-4C5C-8970-BDBF866E42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4263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1F787-034B-4F87-A938-5B1D18C62661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63569-7B5D-4C5C-8970-BDBF866E42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3627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1F787-034B-4F87-A938-5B1D18C62661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63569-7B5D-4C5C-8970-BDBF866E42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93916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1F787-034B-4F87-A938-5B1D18C62661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63569-7B5D-4C5C-8970-BDBF866E42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76354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1F787-034B-4F87-A938-5B1D18C62661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63569-7B5D-4C5C-8970-BDBF866E42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61330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1F787-034B-4F87-A938-5B1D18C62661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63569-7B5D-4C5C-8970-BDBF866E42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73978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1F787-034B-4F87-A938-5B1D18C62661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63569-7B5D-4C5C-8970-BDBF866E42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56280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1F787-034B-4F87-A938-5B1D18C62661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63569-7B5D-4C5C-8970-BDBF866E42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58878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1F787-034B-4F87-A938-5B1D18C62661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63569-7B5D-4C5C-8970-BDBF866E42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83530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1F787-034B-4F87-A938-5B1D18C62661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63569-7B5D-4C5C-8970-BDBF866E42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60159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1F787-034B-4F87-A938-5B1D18C62661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63569-7B5D-4C5C-8970-BDBF866E42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41164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61F787-034B-4F87-A938-5B1D18C62661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B63569-7B5D-4C5C-8970-BDBF866E42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9121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13" Type="http://schemas.openxmlformats.org/officeDocument/2006/relationships/chart" Target="../charts/chart11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12" Type="http://schemas.openxmlformats.org/officeDocument/2006/relationships/chart" Target="../charts/chart10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11" Type="http://schemas.openxmlformats.org/officeDocument/2006/relationships/chart" Target="../charts/chart9.xml"/><Relationship Id="rId5" Type="http://schemas.openxmlformats.org/officeDocument/2006/relationships/chart" Target="../charts/chart3.xml"/><Relationship Id="rId10" Type="http://schemas.openxmlformats.org/officeDocument/2006/relationships/chart" Target="../charts/chart8.xml"/><Relationship Id="rId4" Type="http://schemas.openxmlformats.org/officeDocument/2006/relationships/chart" Target="../charts/chart2.xml"/><Relationship Id="rId9" Type="http://schemas.openxmlformats.org/officeDocument/2006/relationships/chart" Target="../charts/chart7.xml"/><Relationship Id="rId14" Type="http://schemas.openxmlformats.org/officeDocument/2006/relationships/chart" Target="../charts/char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>
            <p:extLst>
              <p:ext uri="{D42A27DB-BD31-4B8C-83A1-F6EECF244321}">
                <p14:modId xmlns:p14="http://schemas.microsoft.com/office/powerpoint/2010/main" val="1331276371"/>
              </p:ext>
            </p:extLst>
          </p:nvPr>
        </p:nvGraphicFramePr>
        <p:xfrm>
          <a:off x="4485005" y="5996453"/>
          <a:ext cx="1980640" cy="15476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Chart 4"/>
          <p:cNvGraphicFramePr/>
          <p:nvPr>
            <p:extLst>
              <p:ext uri="{D42A27DB-BD31-4B8C-83A1-F6EECF244321}">
                <p14:modId xmlns:p14="http://schemas.microsoft.com/office/powerpoint/2010/main" val="2174736840"/>
              </p:ext>
            </p:extLst>
          </p:nvPr>
        </p:nvGraphicFramePr>
        <p:xfrm>
          <a:off x="4485005" y="2689322"/>
          <a:ext cx="1980642" cy="15551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Chart 5"/>
          <p:cNvGraphicFramePr/>
          <p:nvPr>
            <p:extLst>
              <p:ext uri="{D42A27DB-BD31-4B8C-83A1-F6EECF244321}">
                <p14:modId xmlns:p14="http://schemas.microsoft.com/office/powerpoint/2010/main" val="141324748"/>
              </p:ext>
            </p:extLst>
          </p:nvPr>
        </p:nvGraphicFramePr>
        <p:xfrm>
          <a:off x="4485005" y="4200133"/>
          <a:ext cx="1991995" cy="15779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Chart 7"/>
          <p:cNvGraphicFramePr/>
          <p:nvPr>
            <p:extLst>
              <p:ext uri="{D42A27DB-BD31-4B8C-83A1-F6EECF244321}">
                <p14:modId xmlns:p14="http://schemas.microsoft.com/office/powerpoint/2010/main" val="3557740386"/>
              </p:ext>
            </p:extLst>
          </p:nvPr>
        </p:nvGraphicFramePr>
        <p:xfrm>
          <a:off x="4485005" y="1175173"/>
          <a:ext cx="1980642" cy="15551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1" name="Chart 10"/>
          <p:cNvGraphicFramePr/>
          <p:nvPr>
            <p:extLst>
              <p:ext uri="{D42A27DB-BD31-4B8C-83A1-F6EECF244321}">
                <p14:modId xmlns:p14="http://schemas.microsoft.com/office/powerpoint/2010/main" val="74526370"/>
              </p:ext>
            </p:extLst>
          </p:nvPr>
        </p:nvGraphicFramePr>
        <p:xfrm>
          <a:off x="2580005" y="2591075"/>
          <a:ext cx="1916111" cy="14928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2" name="Chart 11"/>
          <p:cNvGraphicFramePr/>
          <p:nvPr>
            <p:extLst>
              <p:ext uri="{D42A27DB-BD31-4B8C-83A1-F6EECF244321}">
                <p14:modId xmlns:p14="http://schemas.microsoft.com/office/powerpoint/2010/main" val="2664715824"/>
              </p:ext>
            </p:extLst>
          </p:nvPr>
        </p:nvGraphicFramePr>
        <p:xfrm>
          <a:off x="2580005" y="5897094"/>
          <a:ext cx="1931352" cy="14624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5" name="Chart 14"/>
          <p:cNvGraphicFramePr/>
          <p:nvPr>
            <p:extLst>
              <p:ext uri="{D42A27DB-BD31-4B8C-83A1-F6EECF244321}">
                <p14:modId xmlns:p14="http://schemas.microsoft.com/office/powerpoint/2010/main" val="670437979"/>
              </p:ext>
            </p:extLst>
          </p:nvPr>
        </p:nvGraphicFramePr>
        <p:xfrm>
          <a:off x="2503805" y="4126148"/>
          <a:ext cx="1946276" cy="15386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6" name="Chart 15"/>
          <p:cNvGraphicFramePr/>
          <p:nvPr>
            <p:extLst>
              <p:ext uri="{D42A27DB-BD31-4B8C-83A1-F6EECF244321}">
                <p14:modId xmlns:p14="http://schemas.microsoft.com/office/powerpoint/2010/main" val="2674357747"/>
              </p:ext>
            </p:extLst>
          </p:nvPr>
        </p:nvGraphicFramePr>
        <p:xfrm>
          <a:off x="547414" y="5867675"/>
          <a:ext cx="1885632" cy="14624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8" name="Chart 17"/>
          <p:cNvGraphicFramePr/>
          <p:nvPr>
            <p:extLst>
              <p:ext uri="{D42A27DB-BD31-4B8C-83A1-F6EECF244321}">
                <p14:modId xmlns:p14="http://schemas.microsoft.com/office/powerpoint/2010/main" val="1628163546"/>
              </p:ext>
            </p:extLst>
          </p:nvPr>
        </p:nvGraphicFramePr>
        <p:xfrm>
          <a:off x="2580005" y="1067075"/>
          <a:ext cx="1885632" cy="14776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20" name="Chart 19"/>
          <p:cNvGraphicFramePr/>
          <p:nvPr>
            <p:extLst>
              <p:ext uri="{D42A27DB-BD31-4B8C-83A1-F6EECF244321}">
                <p14:modId xmlns:p14="http://schemas.microsoft.com/office/powerpoint/2010/main" val="1997723325"/>
              </p:ext>
            </p:extLst>
          </p:nvPr>
        </p:nvGraphicFramePr>
        <p:xfrm>
          <a:off x="522605" y="1067075"/>
          <a:ext cx="1984375" cy="14890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22" name="Chart 21"/>
          <p:cNvGraphicFramePr/>
          <p:nvPr>
            <p:extLst>
              <p:ext uri="{D42A27DB-BD31-4B8C-83A1-F6EECF244321}">
                <p14:modId xmlns:p14="http://schemas.microsoft.com/office/powerpoint/2010/main" val="558979391"/>
              </p:ext>
            </p:extLst>
          </p:nvPr>
        </p:nvGraphicFramePr>
        <p:xfrm>
          <a:off x="535010" y="2667275"/>
          <a:ext cx="1931352" cy="14471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23" name="Chart 22"/>
          <p:cNvGraphicFramePr/>
          <p:nvPr>
            <p:extLst>
              <p:ext uri="{D42A27DB-BD31-4B8C-83A1-F6EECF244321}">
                <p14:modId xmlns:p14="http://schemas.microsoft.com/office/powerpoint/2010/main" val="1835383737"/>
              </p:ext>
            </p:extLst>
          </p:nvPr>
        </p:nvGraphicFramePr>
        <p:xfrm>
          <a:off x="522605" y="4223172"/>
          <a:ext cx="1985964" cy="14890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sp>
        <p:nvSpPr>
          <p:cNvPr id="26" name="Right Arrow 25"/>
          <p:cNvSpPr/>
          <p:nvPr/>
        </p:nvSpPr>
        <p:spPr>
          <a:xfrm>
            <a:off x="2677439" y="7678376"/>
            <a:ext cx="2316480" cy="243650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 Narrow" panose="020B0606020202030204" pitchFamily="34" charset="0"/>
            </a:endParaRPr>
          </a:p>
        </p:txBody>
      </p:sp>
      <p:sp>
        <p:nvSpPr>
          <p:cNvPr id="27" name="Right Arrow 26"/>
          <p:cNvSpPr/>
          <p:nvPr/>
        </p:nvSpPr>
        <p:spPr>
          <a:xfrm rot="16200000">
            <a:off x="-731615" y="3993249"/>
            <a:ext cx="2316480" cy="243650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 Narrow" panose="020B060602020203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2996641" y="7876401"/>
            <a:ext cx="29469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Doppler velocity (mm/s)</a:t>
            </a:r>
            <a:endParaRPr lang="en-US" sz="1200" dirty="0"/>
          </a:p>
        </p:txBody>
      </p:sp>
      <p:sp>
        <p:nvSpPr>
          <p:cNvPr id="29" name="TextBox 28"/>
          <p:cNvSpPr txBox="1"/>
          <p:nvPr/>
        </p:nvSpPr>
        <p:spPr>
          <a:xfrm rot="16200000">
            <a:off x="-1301310" y="3545055"/>
            <a:ext cx="29469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CMR velocity (mm/s)</a:t>
            </a:r>
            <a:endParaRPr lang="en-US" sz="1200" dirty="0"/>
          </a:p>
        </p:txBody>
      </p:sp>
      <p:sp>
        <p:nvSpPr>
          <p:cNvPr id="2" name="TextBox 1"/>
          <p:cNvSpPr txBox="1"/>
          <p:nvPr/>
        </p:nvSpPr>
        <p:spPr>
          <a:xfrm>
            <a:off x="2415540" y="609600"/>
            <a:ext cx="1600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LAD</a:t>
            </a:r>
            <a:endParaRPr lang="en-US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5181600" y="609600"/>
            <a:ext cx="1600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RCA</a:t>
            </a:r>
            <a:endParaRPr lang="en-US" b="1" dirty="0"/>
          </a:p>
        </p:txBody>
      </p:sp>
      <p:sp>
        <p:nvSpPr>
          <p:cNvPr id="3" name="Rectangle 2"/>
          <p:cNvSpPr/>
          <p:nvPr/>
        </p:nvSpPr>
        <p:spPr>
          <a:xfrm>
            <a:off x="624652" y="381000"/>
            <a:ext cx="3852756" cy="7163075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/>
          <p:cNvSpPr/>
          <p:nvPr/>
        </p:nvSpPr>
        <p:spPr>
          <a:xfrm>
            <a:off x="4559388" y="380999"/>
            <a:ext cx="2146212" cy="7163075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53668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7</TotalTime>
  <Words>24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ayo Clini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laire E Raphael</dc:creator>
  <cp:lastModifiedBy>Claire E Raphael</cp:lastModifiedBy>
  <cp:revision>36</cp:revision>
  <dcterms:created xsi:type="dcterms:W3CDTF">2016-10-21T20:29:35Z</dcterms:created>
  <dcterms:modified xsi:type="dcterms:W3CDTF">2016-11-18T15:43:34Z</dcterms:modified>
</cp:coreProperties>
</file>